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4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50" d="100"/>
          <a:sy n="150" d="100"/>
        </p:scale>
        <p:origin x="336" y="-48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EF21FE9-C6EF-47BE-92B4-A03D297664F8}"/>
              </a:ext>
            </a:extLst>
          </p:cNvPr>
          <p:cNvSpPr txBox="1"/>
          <p:nvPr/>
        </p:nvSpPr>
        <p:spPr>
          <a:xfrm>
            <a:off x="529960" y="399744"/>
            <a:ext cx="14540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569E74D4-1428-4CF8-9882-081DAC04CC93}"/>
              </a:ext>
            </a:extLst>
          </p:cNvPr>
          <p:cNvSpPr/>
          <p:nvPr/>
        </p:nvSpPr>
        <p:spPr>
          <a:xfrm>
            <a:off x="467144" y="377174"/>
            <a:ext cx="5923709" cy="49171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897BACEE-1F62-4F67-A8E6-33B23A932DD5}"/>
              </a:ext>
            </a:extLst>
          </p:cNvPr>
          <p:cNvGrpSpPr/>
          <p:nvPr/>
        </p:nvGrpSpPr>
        <p:grpSpPr>
          <a:xfrm>
            <a:off x="886485" y="591244"/>
            <a:ext cx="1725538" cy="719216"/>
            <a:chOff x="993108" y="680727"/>
            <a:chExt cx="1725538" cy="719216"/>
          </a:xfrm>
        </p:grpSpPr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92BE0613-36A6-43B9-8710-386AACB3D144}"/>
                </a:ext>
              </a:extLst>
            </p:cNvPr>
            <p:cNvSpPr/>
            <p:nvPr/>
          </p:nvSpPr>
          <p:spPr>
            <a:xfrm>
              <a:off x="1383792" y="982599"/>
              <a:ext cx="911929" cy="91821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MV35S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C0DC9F13-8178-4FAD-9A60-5986DB651FA1}"/>
                </a:ext>
              </a:extLst>
            </p:cNvPr>
            <p:cNvSpPr txBox="1"/>
            <p:nvPr/>
          </p:nvSpPr>
          <p:spPr>
            <a:xfrm>
              <a:off x="993108" y="680727"/>
              <a:ext cx="7583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da</a:t>
              </a:r>
              <a:r>
                <a:rPr lang="en-US" sz="700" b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am-F</a:t>
              </a:r>
            </a:p>
          </p:txBody>
        </p:sp>
        <p:grpSp>
          <p:nvGrpSpPr>
            <p:cNvPr id="110" name="Group 109">
              <a:extLst>
                <a:ext uri="{FF2B5EF4-FFF2-40B4-BE49-F238E27FC236}">
                  <a16:creationId xmlns:a16="http://schemas.microsoft.com/office/drawing/2014/main" id="{443A8C55-CE9E-4854-A4BA-704A6E65A953}"/>
                </a:ext>
              </a:extLst>
            </p:cNvPr>
            <p:cNvGrpSpPr/>
            <p:nvPr/>
          </p:nvGrpSpPr>
          <p:grpSpPr>
            <a:xfrm>
              <a:off x="1130054" y="883448"/>
              <a:ext cx="497138" cy="41910"/>
              <a:chOff x="5558790" y="222885"/>
              <a:chExt cx="497138" cy="41910"/>
            </a:xfrm>
          </p:grpSpPr>
          <p:cxnSp>
            <p:nvCxnSpPr>
              <p:cNvPr id="120" name="Straight Arrow Connector 119">
                <a:extLst>
                  <a:ext uri="{FF2B5EF4-FFF2-40B4-BE49-F238E27FC236}">
                    <a16:creationId xmlns:a16="http://schemas.microsoft.com/office/drawing/2014/main" id="{D77E84F2-8DBB-4364-9B2A-216DB737BAC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CAD60F7C-11D0-416D-BAB3-1C450CD192BE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E5A1A010-7674-4AA9-B64C-1B1C5B112975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FA355C95-3309-44AA-8E13-096EEDDA2517}"/>
                </a:ext>
              </a:extLst>
            </p:cNvPr>
            <p:cNvSpPr txBox="1"/>
            <p:nvPr/>
          </p:nvSpPr>
          <p:spPr>
            <a:xfrm>
              <a:off x="1960253" y="1199888"/>
              <a:ext cx="7583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m-R-</a:t>
              </a:r>
              <a:r>
                <a:rPr lang="en-US" sz="7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ho</a:t>
              </a:r>
              <a:r>
                <a:rPr lang="en-US" sz="700" b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7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2" name="Group 111">
              <a:extLst>
                <a:ext uri="{FF2B5EF4-FFF2-40B4-BE49-F238E27FC236}">
                  <a16:creationId xmlns:a16="http://schemas.microsoft.com/office/drawing/2014/main" id="{AA000C34-A581-4C37-877D-880736789717}"/>
                </a:ext>
              </a:extLst>
            </p:cNvPr>
            <p:cNvGrpSpPr/>
            <p:nvPr/>
          </p:nvGrpSpPr>
          <p:grpSpPr>
            <a:xfrm flipH="1" flipV="1">
              <a:off x="2053099" y="1130978"/>
              <a:ext cx="462915" cy="64787"/>
              <a:chOff x="5558790" y="222885"/>
              <a:chExt cx="497138" cy="41910"/>
            </a:xfrm>
          </p:grpSpPr>
          <p:cxnSp>
            <p:nvCxnSpPr>
              <p:cNvPr id="117" name="Straight Arrow Connector 116">
                <a:extLst>
                  <a:ext uri="{FF2B5EF4-FFF2-40B4-BE49-F238E27FC236}">
                    <a16:creationId xmlns:a16="http://schemas.microsoft.com/office/drawing/2014/main" id="{EF9203D0-04DB-416A-977A-311D4063CF3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38ACEE83-A750-4DA5-B64E-EDE20455D0B8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5965D29C-C003-45F0-AFD4-4423F4CA17E3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94FE3563-8080-41A4-B2E3-F5B0DF7CBE1E}"/>
              </a:ext>
            </a:extLst>
          </p:cNvPr>
          <p:cNvGrpSpPr/>
          <p:nvPr/>
        </p:nvGrpSpPr>
        <p:grpSpPr>
          <a:xfrm>
            <a:off x="886485" y="1203134"/>
            <a:ext cx="1797543" cy="719216"/>
            <a:chOff x="993108" y="680727"/>
            <a:chExt cx="1797543" cy="719216"/>
          </a:xfrm>
        </p:grpSpPr>
        <p:sp>
          <p:nvSpPr>
            <p:cNvPr id="92" name="Rectangle 91">
              <a:extLst>
                <a:ext uri="{FF2B5EF4-FFF2-40B4-BE49-F238E27FC236}">
                  <a16:creationId xmlns:a16="http://schemas.microsoft.com/office/drawing/2014/main" id="{7AF9A97E-0B82-40E8-B2C5-65EA7F440C1F}"/>
                </a:ext>
              </a:extLst>
            </p:cNvPr>
            <p:cNvSpPr/>
            <p:nvPr/>
          </p:nvSpPr>
          <p:spPr>
            <a:xfrm>
              <a:off x="1383792" y="982599"/>
              <a:ext cx="911929" cy="91821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xFlAG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E446A12-86D5-4F6C-8D19-B9224D3C7E3F}"/>
                </a:ext>
              </a:extLst>
            </p:cNvPr>
            <p:cNvSpPr txBox="1"/>
            <p:nvPr/>
          </p:nvSpPr>
          <p:spPr>
            <a:xfrm>
              <a:off x="993108" y="680727"/>
              <a:ext cx="75839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ho</a:t>
              </a:r>
              <a:r>
                <a:rPr lang="en-US" sz="700" b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Flag-F</a:t>
              </a:r>
            </a:p>
          </p:txBody>
        </p:sp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066CF8CF-9C3A-497C-B0A0-27600021DC2B}"/>
                </a:ext>
              </a:extLst>
            </p:cNvPr>
            <p:cNvGrpSpPr/>
            <p:nvPr/>
          </p:nvGrpSpPr>
          <p:grpSpPr>
            <a:xfrm>
              <a:off x="1130054" y="883448"/>
              <a:ext cx="497138" cy="41910"/>
              <a:chOff x="5558790" y="222885"/>
              <a:chExt cx="497138" cy="41910"/>
            </a:xfrm>
          </p:grpSpPr>
          <p:cxnSp>
            <p:nvCxnSpPr>
              <p:cNvPr id="104" name="Straight Arrow Connector 103">
                <a:extLst>
                  <a:ext uri="{FF2B5EF4-FFF2-40B4-BE49-F238E27FC236}">
                    <a16:creationId xmlns:a16="http://schemas.microsoft.com/office/drawing/2014/main" id="{A72198D9-1D5D-4BC3-839F-B4E57F4B1F0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>
                <a:extLst>
                  <a:ext uri="{FF2B5EF4-FFF2-40B4-BE49-F238E27FC236}">
                    <a16:creationId xmlns:a16="http://schemas.microsoft.com/office/drawing/2014/main" id="{51353046-3CB1-44DD-9A98-BD06BDF06280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FF5ECF94-F332-4755-9E59-634F96CD228D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E88B6FA3-D910-48C6-B26C-5D12E0B9D7CD}"/>
                </a:ext>
              </a:extLst>
            </p:cNvPr>
            <p:cNvSpPr txBox="1"/>
            <p:nvPr/>
          </p:nvSpPr>
          <p:spPr>
            <a:xfrm>
              <a:off x="1960253" y="1199888"/>
              <a:ext cx="830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R2-</a:t>
              </a:r>
              <a:r>
                <a:rPr lang="en-US" sz="700" b="1" i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</a:t>
              </a:r>
              <a:r>
                <a: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</a:p>
          </p:txBody>
        </p: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660282F6-D8EB-4965-B170-D2E520A4A9F6}"/>
                </a:ext>
              </a:extLst>
            </p:cNvPr>
            <p:cNvGrpSpPr/>
            <p:nvPr/>
          </p:nvGrpSpPr>
          <p:grpSpPr>
            <a:xfrm flipH="1" flipV="1">
              <a:off x="2053099" y="1130978"/>
              <a:ext cx="462915" cy="64787"/>
              <a:chOff x="5558790" y="222885"/>
              <a:chExt cx="497138" cy="41910"/>
            </a:xfrm>
          </p:grpSpPr>
          <p:cxnSp>
            <p:nvCxnSpPr>
              <p:cNvPr id="101" name="Straight Arrow Connector 100">
                <a:extLst>
                  <a:ext uri="{FF2B5EF4-FFF2-40B4-BE49-F238E27FC236}">
                    <a16:creationId xmlns:a16="http://schemas.microsoft.com/office/drawing/2014/main" id="{16E62B31-C635-421C-887F-7B19A34B47E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Straight Connector 101">
                <a:extLst>
                  <a:ext uri="{FF2B5EF4-FFF2-40B4-BE49-F238E27FC236}">
                    <a16:creationId xmlns:a16="http://schemas.microsoft.com/office/drawing/2014/main" id="{DFCD8A48-E026-4CF1-838D-B713118418FC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Straight Connector 102">
                <a:extLst>
                  <a:ext uri="{FF2B5EF4-FFF2-40B4-BE49-F238E27FC236}">
                    <a16:creationId xmlns:a16="http://schemas.microsoft.com/office/drawing/2014/main" id="{096FCCF9-AC5A-48CC-8108-E3EEF4DCC5B6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89CCE261-8A59-4A42-AFC5-BC6B10AA2C96}"/>
              </a:ext>
            </a:extLst>
          </p:cNvPr>
          <p:cNvGrpSpPr/>
          <p:nvPr/>
        </p:nvGrpSpPr>
        <p:grpSpPr>
          <a:xfrm>
            <a:off x="885776" y="2020704"/>
            <a:ext cx="1807240" cy="719216"/>
            <a:chOff x="955008" y="680727"/>
            <a:chExt cx="1807240" cy="719216"/>
          </a:xfrm>
        </p:grpSpPr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05901FD4-518F-47F3-A4C1-34C7DA19383D}"/>
                </a:ext>
              </a:extLst>
            </p:cNvPr>
            <p:cNvSpPr/>
            <p:nvPr/>
          </p:nvSpPr>
          <p:spPr>
            <a:xfrm>
              <a:off x="1383792" y="982599"/>
              <a:ext cx="911929" cy="91821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s9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E014064-C2C6-4A77-8425-3D87CC5C99B1}"/>
                </a:ext>
              </a:extLst>
            </p:cNvPr>
            <p:cNvSpPr txBox="1"/>
            <p:nvPr/>
          </p:nvSpPr>
          <p:spPr>
            <a:xfrm>
              <a:off x="955008" y="680727"/>
              <a:ext cx="7975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de</a:t>
              </a:r>
              <a:r>
                <a:rPr lang="en-US" sz="700" b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tIP-F</a:t>
              </a:r>
            </a:p>
          </p:txBody>
        </p:sp>
        <p:grpSp>
          <p:nvGrpSpPr>
            <p:cNvPr id="78" name="Group 77">
              <a:extLst>
                <a:ext uri="{FF2B5EF4-FFF2-40B4-BE49-F238E27FC236}">
                  <a16:creationId xmlns:a16="http://schemas.microsoft.com/office/drawing/2014/main" id="{079F2D54-CA51-400D-B3E7-71A275B31EE3}"/>
                </a:ext>
              </a:extLst>
            </p:cNvPr>
            <p:cNvGrpSpPr/>
            <p:nvPr/>
          </p:nvGrpSpPr>
          <p:grpSpPr>
            <a:xfrm>
              <a:off x="1130054" y="883448"/>
              <a:ext cx="497138" cy="41910"/>
              <a:chOff x="5558790" y="222885"/>
              <a:chExt cx="497138" cy="41910"/>
            </a:xfrm>
          </p:grpSpPr>
          <p:cxnSp>
            <p:nvCxnSpPr>
              <p:cNvPr id="88" name="Straight Arrow Connector 87">
                <a:extLst>
                  <a:ext uri="{FF2B5EF4-FFF2-40B4-BE49-F238E27FC236}">
                    <a16:creationId xmlns:a16="http://schemas.microsoft.com/office/drawing/2014/main" id="{F55B7267-093A-4710-A98C-D0525BA273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8935453E-3557-4273-A5F4-1FB6C9612DE9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4BBA9F2D-6A7D-4060-AEC6-0D0770602F8C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D21AFC1-5B7E-44E5-B787-A27A94B39EC1}"/>
                </a:ext>
              </a:extLst>
            </p:cNvPr>
            <p:cNvSpPr txBox="1"/>
            <p:nvPr/>
          </p:nvSpPr>
          <p:spPr>
            <a:xfrm>
              <a:off x="1964063" y="1199888"/>
              <a:ext cx="79818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IP-R-</a:t>
              </a:r>
              <a:r>
                <a:rPr lang="en-US" sz="7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mH</a:t>
              </a:r>
              <a:r>
                <a:rPr lang="en-US" sz="700" b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7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0" name="Group 79">
              <a:extLst>
                <a:ext uri="{FF2B5EF4-FFF2-40B4-BE49-F238E27FC236}">
                  <a16:creationId xmlns:a16="http://schemas.microsoft.com/office/drawing/2014/main" id="{DBA2E909-01D6-4B68-8C68-C8A28815BA1D}"/>
                </a:ext>
              </a:extLst>
            </p:cNvPr>
            <p:cNvGrpSpPr/>
            <p:nvPr/>
          </p:nvGrpSpPr>
          <p:grpSpPr>
            <a:xfrm flipH="1" flipV="1">
              <a:off x="2053099" y="1130978"/>
              <a:ext cx="462915" cy="64787"/>
              <a:chOff x="5558790" y="222885"/>
              <a:chExt cx="497138" cy="41910"/>
            </a:xfrm>
          </p:grpSpPr>
          <p:cxnSp>
            <p:nvCxnSpPr>
              <p:cNvPr id="85" name="Straight Arrow Connector 84">
                <a:extLst>
                  <a:ext uri="{FF2B5EF4-FFF2-40B4-BE49-F238E27FC236}">
                    <a16:creationId xmlns:a16="http://schemas.microsoft.com/office/drawing/2014/main" id="{2E2F59D4-8193-46AE-AFF7-8CC2F199DEC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96636" y="262128"/>
                <a:ext cx="25929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B1E5805D-EC3D-4B70-A463-21FF80AB65F2}"/>
                  </a:ext>
                </a:extLst>
              </p:cNvPr>
              <p:cNvCxnSpPr/>
              <p:nvPr/>
            </p:nvCxnSpPr>
            <p:spPr>
              <a:xfrm flipV="1">
                <a:off x="5800725" y="222885"/>
                <a:ext cx="0" cy="4191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>
                <a:extLst>
                  <a:ext uri="{FF2B5EF4-FFF2-40B4-BE49-F238E27FC236}">
                    <a16:creationId xmlns:a16="http://schemas.microsoft.com/office/drawing/2014/main" id="{7DACB4F2-E41B-484D-B60D-8CC841749563}"/>
                  </a:ext>
                </a:extLst>
              </p:cNvPr>
              <p:cNvCxnSpPr/>
              <p:nvPr/>
            </p:nvCxnSpPr>
            <p:spPr>
              <a:xfrm>
                <a:off x="5558790" y="222885"/>
                <a:ext cx="24546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CDAC2E65-9A43-403F-9EFF-106949613DF7}"/>
              </a:ext>
            </a:extLst>
          </p:cNvPr>
          <p:cNvGrpSpPr/>
          <p:nvPr/>
        </p:nvGrpSpPr>
        <p:grpSpPr>
          <a:xfrm>
            <a:off x="543454" y="3677537"/>
            <a:ext cx="1789044" cy="701565"/>
            <a:chOff x="1015310" y="3261786"/>
            <a:chExt cx="1789044" cy="701565"/>
          </a:xfrm>
        </p:grpSpPr>
        <p:grpSp>
          <p:nvGrpSpPr>
            <p:cNvPr id="57" name="Group 56">
              <a:extLst>
                <a:ext uri="{FF2B5EF4-FFF2-40B4-BE49-F238E27FC236}">
                  <a16:creationId xmlns:a16="http://schemas.microsoft.com/office/drawing/2014/main" id="{E53C7442-C287-4827-9CE1-40520EED007C}"/>
                </a:ext>
              </a:extLst>
            </p:cNvPr>
            <p:cNvGrpSpPr/>
            <p:nvPr/>
          </p:nvGrpSpPr>
          <p:grpSpPr>
            <a:xfrm>
              <a:off x="1015310" y="3261786"/>
              <a:ext cx="1789044" cy="701565"/>
              <a:chOff x="1008122" y="691449"/>
              <a:chExt cx="1789044" cy="701565"/>
            </a:xfrm>
          </p:grpSpPr>
          <p:sp>
            <p:nvSpPr>
              <p:cNvPr id="60" name="Rectangle 59">
                <a:extLst>
                  <a:ext uri="{FF2B5EF4-FFF2-40B4-BE49-F238E27FC236}">
                    <a16:creationId xmlns:a16="http://schemas.microsoft.com/office/drawing/2014/main" id="{0701E401-11A3-493C-A900-F4AC4C98E5D1}"/>
                  </a:ext>
                </a:extLst>
              </p:cNvPr>
              <p:cNvSpPr/>
              <p:nvPr/>
            </p:nvSpPr>
            <p:spPr>
              <a:xfrm>
                <a:off x="1383792" y="982599"/>
                <a:ext cx="436801" cy="91821"/>
              </a:xfrm>
              <a:prstGeom prst="rec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6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’UTR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12F11E3A-6A2D-4666-9EAC-D4CE02162EDD}"/>
                  </a:ext>
                </a:extLst>
              </p:cNvPr>
              <p:cNvSpPr txBox="1"/>
              <p:nvPr/>
            </p:nvSpPr>
            <p:spPr>
              <a:xfrm>
                <a:off x="1008122" y="691449"/>
                <a:ext cx="79759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7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A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F</a:t>
                </a:r>
              </a:p>
            </p:txBody>
          </p: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D6E55594-7175-4A6B-B118-64B00B9060E1}"/>
                  </a:ext>
                </a:extLst>
              </p:cNvPr>
              <p:cNvGrpSpPr/>
              <p:nvPr/>
            </p:nvGrpSpPr>
            <p:grpSpPr>
              <a:xfrm>
                <a:off x="1130054" y="883448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72" name="Straight Arrow Connector 71">
                  <a:extLst>
                    <a:ext uri="{FF2B5EF4-FFF2-40B4-BE49-F238E27FC236}">
                      <a16:creationId xmlns:a16="http://schemas.microsoft.com/office/drawing/2014/main" id="{1C339848-3068-4A67-A34D-ADF37EE271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Straight Connector 72">
                  <a:extLst>
                    <a:ext uri="{FF2B5EF4-FFF2-40B4-BE49-F238E27FC236}">
                      <a16:creationId xmlns:a16="http://schemas.microsoft.com/office/drawing/2014/main" id="{6A2570D9-4DE8-41FB-BBD1-82603C1E933C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Connector 73">
                  <a:extLst>
                    <a:ext uri="{FF2B5EF4-FFF2-40B4-BE49-F238E27FC236}">
                      <a16:creationId xmlns:a16="http://schemas.microsoft.com/office/drawing/2014/main" id="{B34594A0-8CDC-488D-B7F0-DEE819A944DB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E057440E-82C6-48FB-8A7A-68977530A83B}"/>
                  </a:ext>
                </a:extLst>
              </p:cNvPr>
              <p:cNvSpPr txBox="1"/>
              <p:nvPr/>
            </p:nvSpPr>
            <p:spPr>
              <a:xfrm>
                <a:off x="1998981" y="1192959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olyA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R-</a:t>
                </a:r>
                <a:r>
                  <a:rPr lang="en-US" sz="700" b="1" i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me</a:t>
                </a:r>
                <a:r>
                  <a:rPr lang="en-US" sz="7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</a:p>
            </p:txBody>
          </p:sp>
          <p:grpSp>
            <p:nvGrpSpPr>
              <p:cNvPr id="64" name="Group 63">
                <a:extLst>
                  <a:ext uri="{FF2B5EF4-FFF2-40B4-BE49-F238E27FC236}">
                    <a16:creationId xmlns:a16="http://schemas.microsoft.com/office/drawing/2014/main" id="{8042E608-7239-4CDF-BB59-FE2BCF842AEB}"/>
                  </a:ext>
                </a:extLst>
              </p:cNvPr>
              <p:cNvGrpSpPr/>
              <p:nvPr/>
            </p:nvGrpSpPr>
            <p:grpSpPr>
              <a:xfrm flipH="1" flipV="1">
                <a:off x="2053099" y="1130978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69" name="Straight Arrow Connector 68">
                  <a:extLst>
                    <a:ext uri="{FF2B5EF4-FFF2-40B4-BE49-F238E27FC236}">
                      <a16:creationId xmlns:a16="http://schemas.microsoft.com/office/drawing/2014/main" id="{70284FD8-AEA3-493D-9513-29D8927C44A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0" name="Straight Connector 69">
                  <a:extLst>
                    <a:ext uri="{FF2B5EF4-FFF2-40B4-BE49-F238E27FC236}">
                      <a16:creationId xmlns:a16="http://schemas.microsoft.com/office/drawing/2014/main" id="{41FE38C6-08D3-4961-8B94-8AD511C7A6E2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1" name="Straight Connector 70">
                  <a:extLst>
                    <a:ext uri="{FF2B5EF4-FFF2-40B4-BE49-F238E27FC236}">
                      <a16:creationId xmlns:a16="http://schemas.microsoft.com/office/drawing/2014/main" id="{1FA9EC48-0908-4F2A-81F9-F7AC019536F6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37A09131-97AC-45F7-885C-5D3BCB4A1766}"/>
                </a:ext>
              </a:extLst>
            </p:cNvPr>
            <p:cNvSpPr/>
            <p:nvPr/>
          </p:nvSpPr>
          <p:spPr>
            <a:xfrm>
              <a:off x="1834314" y="3553682"/>
              <a:ext cx="463605" cy="9182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6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olyA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5A19967C-A671-416B-9B0D-EB08B8A89D20}"/>
              </a:ext>
            </a:extLst>
          </p:cNvPr>
          <p:cNvGrpSpPr/>
          <p:nvPr/>
        </p:nvGrpSpPr>
        <p:grpSpPr>
          <a:xfrm>
            <a:off x="962944" y="2689179"/>
            <a:ext cx="1669711" cy="716139"/>
            <a:chOff x="963681" y="6857846"/>
            <a:chExt cx="1669711" cy="716139"/>
          </a:xfrm>
        </p:grpSpPr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BEED4D5A-C8C5-4F4E-AF95-2A344DC74738}"/>
                </a:ext>
              </a:extLst>
            </p:cNvPr>
            <p:cNvSpPr/>
            <p:nvPr/>
          </p:nvSpPr>
          <p:spPr>
            <a:xfrm>
              <a:off x="1381570" y="7156641"/>
              <a:ext cx="785295" cy="91821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IP</a:t>
              </a:r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63822661-9FAD-43AF-85D3-0AF2C47DFDE0}"/>
                </a:ext>
              </a:extLst>
            </p:cNvPr>
            <p:cNvGrpSpPr/>
            <p:nvPr/>
          </p:nvGrpSpPr>
          <p:grpSpPr>
            <a:xfrm>
              <a:off x="963681" y="6857846"/>
              <a:ext cx="797591" cy="244631"/>
              <a:chOff x="826152" y="6854769"/>
              <a:chExt cx="797591" cy="244631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802F973-4EBE-42E4-8122-B15989C1AC96}"/>
                  </a:ext>
                </a:extLst>
              </p:cNvPr>
              <p:cNvSpPr txBox="1"/>
              <p:nvPr/>
            </p:nvSpPr>
            <p:spPr>
              <a:xfrm>
                <a:off x="826152" y="6854769"/>
                <a:ext cx="79759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mH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CtIP-F</a:t>
                </a:r>
              </a:p>
            </p:txBody>
          </p: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024765B2-E97E-47D0-8629-C672D482EC67}"/>
                  </a:ext>
                </a:extLst>
              </p:cNvPr>
              <p:cNvGrpSpPr/>
              <p:nvPr/>
            </p:nvGrpSpPr>
            <p:grpSpPr>
              <a:xfrm>
                <a:off x="1001198" y="7057490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51" name="Straight Arrow Connector 50">
                  <a:extLst>
                    <a:ext uri="{FF2B5EF4-FFF2-40B4-BE49-F238E27FC236}">
                      <a16:creationId xmlns:a16="http://schemas.microsoft.com/office/drawing/2014/main" id="{EC6EAA4C-EC0B-4227-A586-DABE61730E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>
                  <a:extLst>
                    <a:ext uri="{FF2B5EF4-FFF2-40B4-BE49-F238E27FC236}">
                      <a16:creationId xmlns:a16="http://schemas.microsoft.com/office/drawing/2014/main" id="{C1ACC332-218A-4C6C-9D81-3AA1FFA47DCE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>
                  <a:extLst>
                    <a:ext uri="{FF2B5EF4-FFF2-40B4-BE49-F238E27FC236}">
                      <a16:creationId xmlns:a16="http://schemas.microsoft.com/office/drawing/2014/main" id="{B3AEE199-3E4B-4C8B-9C33-C2B2F7993CCF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79B2C0B1-94A5-4F67-BCD1-B106E3CF259D}"/>
                </a:ext>
              </a:extLst>
            </p:cNvPr>
            <p:cNvGrpSpPr/>
            <p:nvPr/>
          </p:nvGrpSpPr>
          <p:grpSpPr>
            <a:xfrm>
              <a:off x="1835207" y="7305020"/>
              <a:ext cx="798185" cy="268965"/>
              <a:chOff x="1835207" y="7305020"/>
              <a:chExt cx="798185" cy="268965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E9E94B5-0667-4005-9721-511A69E7C097}"/>
                  </a:ext>
                </a:extLst>
              </p:cNvPr>
              <p:cNvSpPr txBox="1"/>
              <p:nvPr/>
            </p:nvSpPr>
            <p:spPr>
              <a:xfrm>
                <a:off x="1835207" y="7373930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IP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u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618A52A7-6D52-4F5F-959D-17E4244ECFED}"/>
                  </a:ext>
                </a:extLst>
              </p:cNvPr>
              <p:cNvGrpSpPr/>
              <p:nvPr/>
            </p:nvGrpSpPr>
            <p:grpSpPr>
              <a:xfrm flipH="1" flipV="1">
                <a:off x="1924243" y="7305020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46" name="Straight Arrow Connector 45">
                  <a:extLst>
                    <a:ext uri="{FF2B5EF4-FFF2-40B4-BE49-F238E27FC236}">
                      <a16:creationId xmlns:a16="http://schemas.microsoft.com/office/drawing/2014/main" id="{C904FBD6-6562-4EB5-AC02-A9C138709B5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" name="Straight Connector 46">
                  <a:extLst>
                    <a:ext uri="{FF2B5EF4-FFF2-40B4-BE49-F238E27FC236}">
                      <a16:creationId xmlns:a16="http://schemas.microsoft.com/office/drawing/2014/main" id="{AAEA60DB-90C3-4750-9649-F586B750AF0B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BF958A3E-1CD3-427A-87DC-F3968501A7A1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351A6B8-0890-4FBB-892F-238BBB876293}"/>
              </a:ext>
            </a:extLst>
          </p:cNvPr>
          <p:cNvGrpSpPr/>
          <p:nvPr/>
        </p:nvGrpSpPr>
        <p:grpSpPr>
          <a:xfrm>
            <a:off x="4363257" y="970399"/>
            <a:ext cx="1656766" cy="715037"/>
            <a:chOff x="976626" y="5513594"/>
            <a:chExt cx="1656766" cy="715037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A4CD2CBE-D9B3-4129-94E0-5DC6DB4298D5}"/>
                </a:ext>
              </a:extLst>
            </p:cNvPr>
            <p:cNvSpPr/>
            <p:nvPr/>
          </p:nvSpPr>
          <p:spPr>
            <a:xfrm>
              <a:off x="1381570" y="5811287"/>
              <a:ext cx="785295" cy="91821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E11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26C58357-8069-4B49-B369-528BB4F01934}"/>
                </a:ext>
              </a:extLst>
            </p:cNvPr>
            <p:cNvGrpSpPr/>
            <p:nvPr/>
          </p:nvGrpSpPr>
          <p:grpSpPr>
            <a:xfrm>
              <a:off x="976626" y="5513594"/>
              <a:ext cx="797591" cy="244631"/>
              <a:chOff x="826152" y="5509415"/>
              <a:chExt cx="797591" cy="244631"/>
            </a:xfrm>
          </p:grpSpPr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6AA5120-60DC-473B-A91A-06FB38B4F8DE}"/>
                  </a:ext>
                </a:extLst>
              </p:cNvPr>
              <p:cNvSpPr txBox="1"/>
              <p:nvPr/>
            </p:nvSpPr>
            <p:spPr>
              <a:xfrm>
                <a:off x="826152" y="5509415"/>
                <a:ext cx="79759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t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MRE-F</a:t>
                </a:r>
              </a:p>
            </p:txBody>
          </p: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7E4D1E1A-1F07-4147-94C0-65B43DB33E55}"/>
                  </a:ext>
                </a:extLst>
              </p:cNvPr>
              <p:cNvGrpSpPr/>
              <p:nvPr/>
            </p:nvGrpSpPr>
            <p:grpSpPr>
              <a:xfrm>
                <a:off x="1001198" y="5712136"/>
                <a:ext cx="497138" cy="41910"/>
                <a:chOff x="5558790" y="222885"/>
                <a:chExt cx="497138" cy="41910"/>
              </a:xfrm>
            </p:grpSpPr>
            <p:cxnSp>
              <p:nvCxnSpPr>
                <p:cNvPr id="28" name="Straight Arrow Connector 27">
                  <a:extLst>
                    <a:ext uri="{FF2B5EF4-FFF2-40B4-BE49-F238E27FC236}">
                      <a16:creationId xmlns:a16="http://schemas.microsoft.com/office/drawing/2014/main" id="{B7D88541-8811-4B8E-822F-5B8749CEE87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>
                  <a:extLst>
                    <a:ext uri="{FF2B5EF4-FFF2-40B4-BE49-F238E27FC236}">
                      <a16:creationId xmlns:a16="http://schemas.microsoft.com/office/drawing/2014/main" id="{43A69C59-9859-44DD-865D-C4D59ABC77D2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5EDDFCC1-6099-4C63-A8D8-BA88D634BC4F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FC8600CF-355E-406B-B134-5CA74BEF06AB}"/>
                </a:ext>
              </a:extLst>
            </p:cNvPr>
            <p:cNvGrpSpPr/>
            <p:nvPr/>
          </p:nvGrpSpPr>
          <p:grpSpPr>
            <a:xfrm>
              <a:off x="1835207" y="5959666"/>
              <a:ext cx="798185" cy="268965"/>
              <a:chOff x="1835207" y="5959666"/>
              <a:chExt cx="798185" cy="268965"/>
            </a:xfrm>
          </p:grpSpPr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3035CB8C-E6CE-4A63-A528-ABD9A3C12A80}"/>
                  </a:ext>
                </a:extLst>
              </p:cNvPr>
              <p:cNvSpPr txBox="1"/>
              <p:nvPr/>
            </p:nvSpPr>
            <p:spPr>
              <a:xfrm>
                <a:off x="1835207" y="6028576"/>
                <a:ext cx="79818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E-R-</a:t>
                </a:r>
                <a:r>
                  <a:rPr lang="en-US" sz="700" b="1" i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e</a:t>
                </a:r>
                <a:r>
                  <a:rPr lang="en-US" sz="700" b="1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US" sz="7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7924CA37-D9E0-4FE3-A5E6-558404720AF6}"/>
                  </a:ext>
                </a:extLst>
              </p:cNvPr>
              <p:cNvGrpSpPr/>
              <p:nvPr/>
            </p:nvGrpSpPr>
            <p:grpSpPr>
              <a:xfrm flipH="1" flipV="1">
                <a:off x="1924243" y="5959666"/>
                <a:ext cx="462915" cy="64787"/>
                <a:chOff x="5558790" y="222885"/>
                <a:chExt cx="497138" cy="41910"/>
              </a:xfrm>
            </p:grpSpPr>
            <p:cxnSp>
              <p:nvCxnSpPr>
                <p:cNvPr id="23" name="Straight Arrow Connector 22">
                  <a:extLst>
                    <a:ext uri="{FF2B5EF4-FFF2-40B4-BE49-F238E27FC236}">
                      <a16:creationId xmlns:a16="http://schemas.microsoft.com/office/drawing/2014/main" id="{AA8322A7-3958-4C79-B9AB-1B8F680863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796636" y="262128"/>
                  <a:ext cx="259292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>
                  <a:extLst>
                    <a:ext uri="{FF2B5EF4-FFF2-40B4-BE49-F238E27FC236}">
                      <a16:creationId xmlns:a16="http://schemas.microsoft.com/office/drawing/2014/main" id="{5C3A43AC-EF9E-4329-80B1-2BFDA83ED69B}"/>
                    </a:ext>
                  </a:extLst>
                </p:cNvPr>
                <p:cNvCxnSpPr/>
                <p:nvPr/>
              </p:nvCxnSpPr>
              <p:spPr>
                <a:xfrm flipV="1">
                  <a:off x="5800725" y="222885"/>
                  <a:ext cx="0" cy="4191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>
                  <a:extLst>
                    <a:ext uri="{FF2B5EF4-FFF2-40B4-BE49-F238E27FC236}">
                      <a16:creationId xmlns:a16="http://schemas.microsoft.com/office/drawing/2014/main" id="{943E924C-7471-46FE-A1E7-81D16C0DA1E8}"/>
                    </a:ext>
                  </a:extLst>
                </p:cNvPr>
                <p:cNvCxnSpPr/>
                <p:nvPr/>
              </p:nvCxnSpPr>
              <p:spPr>
                <a:xfrm>
                  <a:off x="5558790" y="222885"/>
                  <a:ext cx="24546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124" name="Right Brace 123">
            <a:extLst>
              <a:ext uri="{FF2B5EF4-FFF2-40B4-BE49-F238E27FC236}">
                <a16:creationId xmlns:a16="http://schemas.microsoft.com/office/drawing/2014/main" id="{B0CE5AA4-21D5-4287-802E-97DF2582B4C3}"/>
              </a:ext>
            </a:extLst>
          </p:cNvPr>
          <p:cNvSpPr/>
          <p:nvPr/>
        </p:nvSpPr>
        <p:spPr>
          <a:xfrm>
            <a:off x="2888548" y="978585"/>
            <a:ext cx="128080" cy="753920"/>
          </a:xfrm>
          <a:prstGeom prst="rightBrace">
            <a:avLst>
              <a:gd name="adj1" fmla="val 140677"/>
              <a:gd name="adj2" fmla="val 47798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EB064530-38CA-48F2-8D7D-F6CF7814A7A1}"/>
              </a:ext>
            </a:extLst>
          </p:cNvPr>
          <p:cNvSpPr txBox="1"/>
          <p:nvPr/>
        </p:nvSpPr>
        <p:spPr>
          <a:xfrm>
            <a:off x="3805974" y="1247310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kbone 1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BAB44D8D-CB30-493F-80EE-DC24EF558A25}"/>
              </a:ext>
            </a:extLst>
          </p:cNvPr>
          <p:cNvSpPr txBox="1"/>
          <p:nvPr/>
        </p:nvSpPr>
        <p:spPr>
          <a:xfrm>
            <a:off x="2868053" y="1124712"/>
            <a:ext cx="911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</a:p>
          <a:p>
            <a:pPr algn="ctr"/>
            <a:r>
              <a:rPr lang="en-US" sz="800" b="1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Xho</a:t>
            </a:r>
            <a:r>
              <a:rPr lang="en-US" sz="8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0E41C914-E697-445D-B3A2-A77DADC9195E}"/>
              </a:ext>
            </a:extLst>
          </p:cNvPr>
          <p:cNvCxnSpPr>
            <a:cxnSpLocks/>
          </p:cNvCxnSpPr>
          <p:nvPr/>
        </p:nvCxnSpPr>
        <p:spPr>
          <a:xfrm>
            <a:off x="3590206" y="1363356"/>
            <a:ext cx="199473" cy="241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34" name="Group 133">
            <a:extLst>
              <a:ext uri="{FF2B5EF4-FFF2-40B4-BE49-F238E27FC236}">
                <a16:creationId xmlns:a16="http://schemas.microsoft.com/office/drawing/2014/main" id="{4FB94A7D-F440-4740-88D8-4B15FB7999DE}"/>
              </a:ext>
            </a:extLst>
          </p:cNvPr>
          <p:cNvGrpSpPr/>
          <p:nvPr/>
        </p:nvGrpSpPr>
        <p:grpSpPr>
          <a:xfrm>
            <a:off x="4152702" y="1721127"/>
            <a:ext cx="1842144" cy="952963"/>
            <a:chOff x="3845386" y="1658486"/>
            <a:chExt cx="1842144" cy="952963"/>
          </a:xfrm>
        </p:grpSpPr>
        <p:sp>
          <p:nvSpPr>
            <p:cNvPr id="130" name="Right Brace 129">
              <a:extLst>
                <a:ext uri="{FF2B5EF4-FFF2-40B4-BE49-F238E27FC236}">
                  <a16:creationId xmlns:a16="http://schemas.microsoft.com/office/drawing/2014/main" id="{F103BC91-03BE-4AE4-9BF5-89135BF286FA}"/>
                </a:ext>
              </a:extLst>
            </p:cNvPr>
            <p:cNvSpPr/>
            <p:nvPr/>
          </p:nvSpPr>
          <p:spPr>
            <a:xfrm rot="5400000">
              <a:off x="4672380" y="831492"/>
              <a:ext cx="123968" cy="1777956"/>
            </a:xfrm>
            <a:prstGeom prst="rightBrace">
              <a:avLst>
                <a:gd name="adj1" fmla="val 69106"/>
                <a:gd name="adj2" fmla="val 21189"/>
              </a:avLst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639CCB16-AC2D-424C-A4F2-5B41F17B8591}"/>
                </a:ext>
              </a:extLst>
            </p:cNvPr>
            <p:cNvSpPr txBox="1"/>
            <p:nvPr/>
          </p:nvSpPr>
          <p:spPr>
            <a:xfrm>
              <a:off x="4917934" y="2396005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kbone 2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32667ED7-4533-496E-8226-786418DE7040}"/>
                </a:ext>
              </a:extLst>
            </p:cNvPr>
            <p:cNvSpPr txBox="1"/>
            <p:nvPr/>
          </p:nvSpPr>
          <p:spPr>
            <a:xfrm>
              <a:off x="4775601" y="1788279"/>
              <a:ext cx="91192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triction cloning by </a:t>
              </a:r>
            </a:p>
            <a:p>
              <a:pPr algn="ctr"/>
              <a:r>
                <a:rPr lang="en-US" sz="800" b="1" i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t</a:t>
              </a:r>
              <a:r>
                <a:rPr lang="en-US" sz="800" b="1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endParaRPr 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3" name="Straight Arrow Connector 132">
              <a:extLst>
                <a:ext uri="{FF2B5EF4-FFF2-40B4-BE49-F238E27FC236}">
                  <a16:creationId xmlns:a16="http://schemas.microsoft.com/office/drawing/2014/main" id="{2AFC613C-E316-4E92-BECD-8C4A7F053770}"/>
                </a:ext>
              </a:extLst>
            </p:cNvPr>
            <p:cNvCxnSpPr>
              <a:cxnSpLocks/>
            </p:cNvCxnSpPr>
            <p:nvPr/>
          </p:nvCxnSpPr>
          <p:spPr>
            <a:xfrm>
              <a:off x="5238718" y="2249944"/>
              <a:ext cx="0" cy="1566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0" name="Right Brace 139">
            <a:extLst>
              <a:ext uri="{FF2B5EF4-FFF2-40B4-BE49-F238E27FC236}">
                <a16:creationId xmlns:a16="http://schemas.microsoft.com/office/drawing/2014/main" id="{ACCDCFE2-74CA-4B4E-A129-A13FECCD6F33}"/>
              </a:ext>
            </a:extLst>
          </p:cNvPr>
          <p:cNvSpPr/>
          <p:nvPr/>
        </p:nvSpPr>
        <p:spPr>
          <a:xfrm>
            <a:off x="2952926" y="2272492"/>
            <a:ext cx="128080" cy="929110"/>
          </a:xfrm>
          <a:prstGeom prst="rightBrace">
            <a:avLst>
              <a:gd name="adj1" fmla="val 140677"/>
              <a:gd name="adj2" fmla="val 47798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A6518AD8-A4E6-4EFC-A740-D436F7F787EF}"/>
              </a:ext>
            </a:extLst>
          </p:cNvPr>
          <p:cNvSpPr txBox="1"/>
          <p:nvPr/>
        </p:nvSpPr>
        <p:spPr>
          <a:xfrm>
            <a:off x="2950093" y="2482573"/>
            <a:ext cx="911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</a:p>
          <a:p>
            <a:pPr algn="ctr"/>
            <a:r>
              <a:rPr lang="en-US" sz="800" b="1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mH</a:t>
            </a:r>
            <a:r>
              <a:rPr lang="en-US" sz="8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8A720759-D447-44F7-BADB-36BEE9B5AAF4}"/>
              </a:ext>
            </a:extLst>
          </p:cNvPr>
          <p:cNvSpPr txBox="1"/>
          <p:nvPr/>
        </p:nvSpPr>
        <p:spPr>
          <a:xfrm>
            <a:off x="3882574" y="2584789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kbone 3</a:t>
            </a:r>
          </a:p>
        </p:txBody>
      </p: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C975A3BD-22D8-46B8-A1F4-72F22140AB7B}"/>
              </a:ext>
            </a:extLst>
          </p:cNvPr>
          <p:cNvCxnSpPr>
            <a:cxnSpLocks/>
          </p:cNvCxnSpPr>
          <p:nvPr/>
        </p:nvCxnSpPr>
        <p:spPr>
          <a:xfrm>
            <a:off x="3666806" y="2700835"/>
            <a:ext cx="26687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63FF77AE-5939-4685-BD38-E7541EB7C034}"/>
              </a:ext>
            </a:extLst>
          </p:cNvPr>
          <p:cNvSpPr txBox="1"/>
          <p:nvPr/>
        </p:nvSpPr>
        <p:spPr>
          <a:xfrm>
            <a:off x="2215597" y="3876018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kbone 3</a:t>
            </a:r>
          </a:p>
        </p:txBody>
      </p:sp>
      <p:sp>
        <p:nvSpPr>
          <p:cNvPr id="150" name="Right Brace 149">
            <a:extLst>
              <a:ext uri="{FF2B5EF4-FFF2-40B4-BE49-F238E27FC236}">
                <a16:creationId xmlns:a16="http://schemas.microsoft.com/office/drawing/2014/main" id="{565E7E18-E11A-410C-A72C-758BE0F8A78B}"/>
              </a:ext>
            </a:extLst>
          </p:cNvPr>
          <p:cNvSpPr/>
          <p:nvPr/>
        </p:nvSpPr>
        <p:spPr>
          <a:xfrm>
            <a:off x="2955576" y="3630352"/>
            <a:ext cx="128080" cy="688162"/>
          </a:xfrm>
          <a:prstGeom prst="rightBrace">
            <a:avLst>
              <a:gd name="adj1" fmla="val 140677"/>
              <a:gd name="adj2" fmla="val 47798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A6765137-0A19-4003-AD4F-CB6C43053319}"/>
              </a:ext>
            </a:extLst>
          </p:cNvPr>
          <p:cNvSpPr txBox="1"/>
          <p:nvPr/>
        </p:nvSpPr>
        <p:spPr>
          <a:xfrm>
            <a:off x="2943255" y="3709484"/>
            <a:ext cx="911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</a:p>
          <a:p>
            <a:pPr algn="ctr"/>
            <a:r>
              <a:rPr lang="en-US" sz="800" b="1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u</a:t>
            </a:r>
            <a:r>
              <a:rPr lang="en-US" sz="8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8EBE202-9849-45FB-957F-3ABBA8887628}"/>
              </a:ext>
            </a:extLst>
          </p:cNvPr>
          <p:cNvSpPr txBox="1"/>
          <p:nvPr/>
        </p:nvSpPr>
        <p:spPr>
          <a:xfrm>
            <a:off x="3875736" y="3811700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kbone 4</a:t>
            </a:r>
          </a:p>
        </p:txBody>
      </p:sp>
      <p:cxnSp>
        <p:nvCxnSpPr>
          <p:cNvPr id="153" name="Straight Arrow Connector 152">
            <a:extLst>
              <a:ext uri="{FF2B5EF4-FFF2-40B4-BE49-F238E27FC236}">
                <a16:creationId xmlns:a16="http://schemas.microsoft.com/office/drawing/2014/main" id="{AA3F2818-D4FD-4DE6-BF82-687A3FB14909}"/>
              </a:ext>
            </a:extLst>
          </p:cNvPr>
          <p:cNvCxnSpPr>
            <a:cxnSpLocks/>
          </p:cNvCxnSpPr>
          <p:nvPr/>
        </p:nvCxnSpPr>
        <p:spPr>
          <a:xfrm>
            <a:off x="3659968" y="3927746"/>
            <a:ext cx="26687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19B6F19C-D481-4BF2-8AFE-505EB7462E67}"/>
              </a:ext>
            </a:extLst>
          </p:cNvPr>
          <p:cNvSpPr txBox="1"/>
          <p:nvPr/>
        </p:nvSpPr>
        <p:spPr>
          <a:xfrm>
            <a:off x="820127" y="4480594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kbone 2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7949E3EB-4975-4560-8037-968908BBEA84}"/>
              </a:ext>
            </a:extLst>
          </p:cNvPr>
          <p:cNvSpPr txBox="1"/>
          <p:nvPr/>
        </p:nvSpPr>
        <p:spPr>
          <a:xfrm>
            <a:off x="816777" y="4732546"/>
            <a:ext cx="6960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ckbone 4</a:t>
            </a:r>
          </a:p>
        </p:txBody>
      </p:sp>
      <p:sp>
        <p:nvSpPr>
          <p:cNvPr id="156" name="Right Brace 155">
            <a:extLst>
              <a:ext uri="{FF2B5EF4-FFF2-40B4-BE49-F238E27FC236}">
                <a16:creationId xmlns:a16="http://schemas.microsoft.com/office/drawing/2014/main" id="{BBED3309-B1AB-44AB-A259-1612CBF78471}"/>
              </a:ext>
            </a:extLst>
          </p:cNvPr>
          <p:cNvSpPr/>
          <p:nvPr/>
        </p:nvSpPr>
        <p:spPr>
          <a:xfrm>
            <a:off x="1512661" y="4527581"/>
            <a:ext cx="128080" cy="388628"/>
          </a:xfrm>
          <a:prstGeom prst="rightBrace">
            <a:avLst>
              <a:gd name="adj1" fmla="val 140677"/>
              <a:gd name="adj2" fmla="val 47798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2548B6C6-9A2E-46DF-9B7C-126483F45E27}"/>
              </a:ext>
            </a:extLst>
          </p:cNvPr>
          <p:cNvSpPr txBox="1"/>
          <p:nvPr/>
        </p:nvSpPr>
        <p:spPr>
          <a:xfrm>
            <a:off x="1511730" y="4520168"/>
            <a:ext cx="911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</a:p>
          <a:p>
            <a:pPr algn="ctr"/>
            <a:r>
              <a:rPr lang="en-US" sz="800" b="1" i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de</a:t>
            </a:r>
            <a:r>
              <a:rPr lang="en-US" sz="8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en-US" sz="8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BBA1F821-78AA-450F-BDB5-9DD47B49D5A1}"/>
              </a:ext>
            </a:extLst>
          </p:cNvPr>
          <p:cNvSpPr txBox="1"/>
          <p:nvPr/>
        </p:nvSpPr>
        <p:spPr>
          <a:xfrm>
            <a:off x="2488274" y="4622384"/>
            <a:ext cx="54694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MR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sette</a:t>
            </a:r>
          </a:p>
        </p:txBody>
      </p:sp>
      <p:cxnSp>
        <p:nvCxnSpPr>
          <p:cNvPr id="159" name="Straight Arrow Connector 158">
            <a:extLst>
              <a:ext uri="{FF2B5EF4-FFF2-40B4-BE49-F238E27FC236}">
                <a16:creationId xmlns:a16="http://schemas.microsoft.com/office/drawing/2014/main" id="{2584FFBD-B490-4652-8CDC-49D600003A0C}"/>
              </a:ext>
            </a:extLst>
          </p:cNvPr>
          <p:cNvCxnSpPr>
            <a:cxnSpLocks/>
          </p:cNvCxnSpPr>
          <p:nvPr/>
        </p:nvCxnSpPr>
        <p:spPr>
          <a:xfrm>
            <a:off x="2228443" y="4738430"/>
            <a:ext cx="26687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D0D10AFD-296E-4F3B-87CD-3F134F2F2211}"/>
              </a:ext>
            </a:extLst>
          </p:cNvPr>
          <p:cNvSpPr txBox="1"/>
          <p:nvPr/>
        </p:nvSpPr>
        <p:spPr>
          <a:xfrm>
            <a:off x="4634579" y="4597264"/>
            <a:ext cx="5699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CtMR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60D39F1D-9097-47AD-A45E-0FA4C5C28DB1}"/>
              </a:ext>
            </a:extLst>
          </p:cNvPr>
          <p:cNvSpPr txBox="1"/>
          <p:nvPr/>
        </p:nvSpPr>
        <p:spPr>
          <a:xfrm>
            <a:off x="3080862" y="4840268"/>
            <a:ext cx="6367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GEB31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7C513C33-2168-4642-898F-2C2E5D6D9AF4}"/>
              </a:ext>
            </a:extLst>
          </p:cNvPr>
          <p:cNvSpPr txBox="1"/>
          <p:nvPr/>
        </p:nvSpPr>
        <p:spPr>
          <a:xfrm>
            <a:off x="3052070" y="4359465"/>
            <a:ext cx="5469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tMR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sette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0AE263EC-2701-433C-97E2-D6326BEE598C}"/>
              </a:ext>
            </a:extLst>
          </p:cNvPr>
          <p:cNvSpPr txBox="1"/>
          <p:nvPr/>
        </p:nvSpPr>
        <p:spPr>
          <a:xfrm>
            <a:off x="3681115" y="4474154"/>
            <a:ext cx="911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 cloning by </a:t>
            </a:r>
            <a:r>
              <a:rPr lang="en-US" sz="8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da</a:t>
            </a:r>
            <a:r>
              <a:rPr 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8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me</a:t>
            </a:r>
            <a:r>
              <a:rPr lang="en-US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cxnSp>
        <p:nvCxnSpPr>
          <p:cNvPr id="168" name="Straight Arrow Connector 167">
            <a:extLst>
              <a:ext uri="{FF2B5EF4-FFF2-40B4-BE49-F238E27FC236}">
                <a16:creationId xmlns:a16="http://schemas.microsoft.com/office/drawing/2014/main" id="{AD5C2585-126B-4AF1-B863-89B399007DAD}"/>
              </a:ext>
            </a:extLst>
          </p:cNvPr>
          <p:cNvCxnSpPr>
            <a:cxnSpLocks/>
          </p:cNvCxnSpPr>
          <p:nvPr/>
        </p:nvCxnSpPr>
        <p:spPr>
          <a:xfrm>
            <a:off x="3589835" y="4727735"/>
            <a:ext cx="15546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Arrow Connector 168">
            <a:extLst>
              <a:ext uri="{FF2B5EF4-FFF2-40B4-BE49-F238E27FC236}">
                <a16:creationId xmlns:a16="http://schemas.microsoft.com/office/drawing/2014/main" id="{709BF9DE-EF8A-4FCE-A267-A0C26D4F862C}"/>
              </a:ext>
            </a:extLst>
          </p:cNvPr>
          <p:cNvCxnSpPr>
            <a:cxnSpLocks/>
          </p:cNvCxnSpPr>
          <p:nvPr/>
        </p:nvCxnSpPr>
        <p:spPr>
          <a:xfrm>
            <a:off x="4515510" y="4716134"/>
            <a:ext cx="155467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74" name="Group 273">
            <a:extLst>
              <a:ext uri="{FF2B5EF4-FFF2-40B4-BE49-F238E27FC236}">
                <a16:creationId xmlns:a16="http://schemas.microsoft.com/office/drawing/2014/main" id="{657A8509-DBC5-43E9-817E-4B3507B0F759}"/>
              </a:ext>
            </a:extLst>
          </p:cNvPr>
          <p:cNvGrpSpPr/>
          <p:nvPr/>
        </p:nvGrpSpPr>
        <p:grpSpPr>
          <a:xfrm>
            <a:off x="467145" y="5426616"/>
            <a:ext cx="5923709" cy="2776791"/>
            <a:chOff x="467145" y="5426616"/>
            <a:chExt cx="5923709" cy="2776791"/>
          </a:xfrm>
        </p:grpSpPr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F91D9D24-83C4-4F7B-A148-1B9F4862C3F8}"/>
                </a:ext>
              </a:extLst>
            </p:cNvPr>
            <p:cNvSpPr/>
            <p:nvPr/>
          </p:nvSpPr>
          <p:spPr>
            <a:xfrm>
              <a:off x="467145" y="5426616"/>
              <a:ext cx="5923709" cy="277679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D299BDCA-259C-4F50-A2CC-6CC08AFC085E}"/>
                </a:ext>
              </a:extLst>
            </p:cNvPr>
            <p:cNvSpPr txBox="1"/>
            <p:nvPr/>
          </p:nvSpPr>
          <p:spPr>
            <a:xfrm>
              <a:off x="526496" y="5484581"/>
              <a:ext cx="145405" cy="21544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grpSp>
          <p:nvGrpSpPr>
            <p:cNvPr id="273" name="Group 272">
              <a:extLst>
                <a:ext uri="{FF2B5EF4-FFF2-40B4-BE49-F238E27FC236}">
                  <a16:creationId xmlns:a16="http://schemas.microsoft.com/office/drawing/2014/main" id="{8484D927-FB69-407E-98C3-CD6194BD3ACA}"/>
                </a:ext>
              </a:extLst>
            </p:cNvPr>
            <p:cNvGrpSpPr/>
            <p:nvPr/>
          </p:nvGrpSpPr>
          <p:grpSpPr>
            <a:xfrm>
              <a:off x="665345" y="5726390"/>
              <a:ext cx="5503886" cy="2322131"/>
              <a:chOff x="665345" y="5726390"/>
              <a:chExt cx="5503886" cy="2322131"/>
            </a:xfrm>
          </p:grpSpPr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DCC20B29-79AD-4156-872B-EA4897C0151C}"/>
                  </a:ext>
                </a:extLst>
              </p:cNvPr>
              <p:cNvSpPr txBox="1"/>
              <p:nvPr/>
            </p:nvSpPr>
            <p:spPr>
              <a:xfrm>
                <a:off x="5059502" y="7709967"/>
                <a:ext cx="110972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KK2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Oligo: MKO</a:t>
                </a:r>
              </a:p>
              <a:p>
                <a:r>
                  <a:rPr lang="en-US" sz="8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RCC4</a:t>
                </a:r>
                <a:r>
                  <a: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Oligo: XRO</a:t>
                </a:r>
              </a:p>
            </p:txBody>
          </p:sp>
          <p:grpSp>
            <p:nvGrpSpPr>
              <p:cNvPr id="263" name="Group 262">
                <a:extLst>
                  <a:ext uri="{FF2B5EF4-FFF2-40B4-BE49-F238E27FC236}">
                    <a16:creationId xmlns:a16="http://schemas.microsoft.com/office/drawing/2014/main" id="{449B96EA-16DC-4EF2-96D5-254CF7BE0794}"/>
                  </a:ext>
                </a:extLst>
              </p:cNvPr>
              <p:cNvGrpSpPr/>
              <p:nvPr/>
            </p:nvGrpSpPr>
            <p:grpSpPr>
              <a:xfrm>
                <a:off x="665345" y="5726390"/>
                <a:ext cx="5497785" cy="1390860"/>
                <a:chOff x="665345" y="5726390"/>
                <a:chExt cx="5497785" cy="1390860"/>
              </a:xfrm>
            </p:grpSpPr>
            <p:grpSp>
              <p:nvGrpSpPr>
                <p:cNvPr id="249" name="Group 248">
                  <a:extLst>
                    <a:ext uri="{FF2B5EF4-FFF2-40B4-BE49-F238E27FC236}">
                      <a16:creationId xmlns:a16="http://schemas.microsoft.com/office/drawing/2014/main" id="{E2BD7D57-EB2B-43EC-9A26-79D2DDF71584}"/>
                    </a:ext>
                  </a:extLst>
                </p:cNvPr>
                <p:cNvGrpSpPr/>
                <p:nvPr/>
              </p:nvGrpSpPr>
              <p:grpSpPr>
                <a:xfrm>
                  <a:off x="665345" y="6441744"/>
                  <a:ext cx="2108196" cy="675506"/>
                  <a:chOff x="847368" y="6442351"/>
                  <a:chExt cx="2108196" cy="675506"/>
                </a:xfrm>
              </p:grpSpPr>
              <p:grpSp>
                <p:nvGrpSpPr>
                  <p:cNvPr id="179" name="Group 178">
                    <a:extLst>
                      <a:ext uri="{FF2B5EF4-FFF2-40B4-BE49-F238E27FC236}">
                        <a16:creationId xmlns:a16="http://schemas.microsoft.com/office/drawing/2014/main" id="{B7A0B681-9CC7-4A23-9E17-3B2473F1A545}"/>
                      </a:ext>
                    </a:extLst>
                  </p:cNvPr>
                  <p:cNvGrpSpPr/>
                  <p:nvPr/>
                </p:nvGrpSpPr>
                <p:grpSpPr>
                  <a:xfrm>
                    <a:off x="1637947" y="6483207"/>
                    <a:ext cx="501314" cy="200055"/>
                    <a:chOff x="4490412" y="4917116"/>
                    <a:chExt cx="501314" cy="200055"/>
                  </a:xfrm>
                </p:grpSpPr>
                <p:sp>
                  <p:nvSpPr>
                    <p:cNvPr id="246" name="TextBox 245">
                      <a:extLst>
                        <a:ext uri="{FF2B5EF4-FFF2-40B4-BE49-F238E27FC236}">
                          <a16:creationId xmlns:a16="http://schemas.microsoft.com/office/drawing/2014/main" id="{8B3BF49E-4E83-478F-B1CF-47F1715B4DC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490412" y="4917116"/>
                      <a:ext cx="50131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RO-1</a:t>
                      </a:r>
                    </a:p>
                  </p:txBody>
                </p:sp>
                <p:cxnSp>
                  <p:nvCxnSpPr>
                    <p:cNvPr id="247" name="Straight Arrow Connector 246">
                      <a:extLst>
                        <a:ext uri="{FF2B5EF4-FFF2-40B4-BE49-F238E27FC236}">
                          <a16:creationId xmlns:a16="http://schemas.microsoft.com/office/drawing/2014/main" id="{F2365793-0CFA-4DCE-A606-0B2E5515D54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644353" y="5114564"/>
                      <a:ext cx="174431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80" name="Group 179">
                    <a:extLst>
                      <a:ext uri="{FF2B5EF4-FFF2-40B4-BE49-F238E27FC236}">
                        <a16:creationId xmlns:a16="http://schemas.microsoft.com/office/drawing/2014/main" id="{37C42394-A3D8-493E-95AB-264E72FF4C63}"/>
                      </a:ext>
                    </a:extLst>
                  </p:cNvPr>
                  <p:cNvGrpSpPr/>
                  <p:nvPr/>
                </p:nvGrpSpPr>
                <p:grpSpPr>
                  <a:xfrm>
                    <a:off x="1668729" y="6867571"/>
                    <a:ext cx="501314" cy="200055"/>
                    <a:chOff x="4521194" y="5301480"/>
                    <a:chExt cx="501314" cy="200055"/>
                  </a:xfrm>
                </p:grpSpPr>
                <p:sp>
                  <p:nvSpPr>
                    <p:cNvPr id="244" name="TextBox 243">
                      <a:extLst>
                        <a:ext uri="{FF2B5EF4-FFF2-40B4-BE49-F238E27FC236}">
                          <a16:creationId xmlns:a16="http://schemas.microsoft.com/office/drawing/2014/main" id="{56C3F64D-9D48-4AA9-A2CB-B036361C10C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21194" y="5301480"/>
                      <a:ext cx="50131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RO-2</a:t>
                      </a:r>
                    </a:p>
                  </p:txBody>
                </p:sp>
                <p:cxnSp>
                  <p:nvCxnSpPr>
                    <p:cNvPr id="245" name="Straight Arrow Connector 244">
                      <a:extLst>
                        <a:ext uri="{FF2B5EF4-FFF2-40B4-BE49-F238E27FC236}">
                          <a16:creationId xmlns:a16="http://schemas.microsoft.com/office/drawing/2014/main" id="{21E022F6-229A-4C08-8D07-EC7D7ED6CC5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682707" y="5306406"/>
                      <a:ext cx="165633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95" name="Group 194">
                    <a:extLst>
                      <a:ext uri="{FF2B5EF4-FFF2-40B4-BE49-F238E27FC236}">
                        <a16:creationId xmlns:a16="http://schemas.microsoft.com/office/drawing/2014/main" id="{EE5F6C54-AE15-402C-8090-9D69C91960E0}"/>
                      </a:ext>
                    </a:extLst>
                  </p:cNvPr>
                  <p:cNvGrpSpPr/>
                  <p:nvPr/>
                </p:nvGrpSpPr>
                <p:grpSpPr>
                  <a:xfrm>
                    <a:off x="847368" y="6442351"/>
                    <a:ext cx="2108196" cy="675506"/>
                    <a:chOff x="3653810" y="4131767"/>
                    <a:chExt cx="2108196" cy="675506"/>
                  </a:xfrm>
                </p:grpSpPr>
                <p:grpSp>
                  <p:nvGrpSpPr>
                    <p:cNvPr id="196" name="Group 195">
                      <a:extLst>
                        <a:ext uri="{FF2B5EF4-FFF2-40B4-BE49-F238E27FC236}">
                          <a16:creationId xmlns:a16="http://schemas.microsoft.com/office/drawing/2014/main" id="{84A6CC2D-BE7C-407E-990B-194E85E8AA6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653810" y="4131767"/>
                      <a:ext cx="2108196" cy="675506"/>
                      <a:chOff x="3653810" y="4131767"/>
                      <a:chExt cx="2108196" cy="675506"/>
                    </a:xfrm>
                  </p:grpSpPr>
                  <p:grpSp>
                    <p:nvGrpSpPr>
                      <p:cNvPr id="198" name="Group 197">
                        <a:extLst>
                          <a:ext uri="{FF2B5EF4-FFF2-40B4-BE49-F238E27FC236}">
                            <a16:creationId xmlns:a16="http://schemas.microsoft.com/office/drawing/2014/main" id="{8ABCFE4D-7CBE-421B-BA19-04F26B2EB126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653810" y="4131767"/>
                        <a:ext cx="973671" cy="230358"/>
                        <a:chOff x="3653810" y="4131767"/>
                        <a:chExt cx="973671" cy="230358"/>
                      </a:xfrm>
                    </p:grpSpPr>
                    <p:sp>
                      <p:nvSpPr>
                        <p:cNvPr id="210" name="TextBox 209">
                          <a:extLst>
                            <a:ext uri="{FF2B5EF4-FFF2-40B4-BE49-F238E27FC236}">
                              <a16:creationId xmlns:a16="http://schemas.microsoft.com/office/drawing/2014/main" id="{D1E4C6CF-F93E-4982-8F20-EB973D4A107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653810" y="4131767"/>
                          <a:ext cx="973671" cy="20005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700" b="1" i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Kas</a:t>
                          </a:r>
                          <a:r>
                            <a:rPr lang="en-US" sz="700" b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</a:t>
                          </a:r>
                          <a:r>
                            <a:rPr lang="en-US" sz="7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XR-Cass2-F</a:t>
                          </a:r>
                        </a:p>
                      </p:txBody>
                    </p:sp>
                    <p:grpSp>
                      <p:nvGrpSpPr>
                        <p:cNvPr id="211" name="Group 210">
                          <a:extLst>
                            <a:ext uri="{FF2B5EF4-FFF2-40B4-BE49-F238E27FC236}">
                              <a16:creationId xmlns:a16="http://schemas.microsoft.com/office/drawing/2014/main" id="{5B3287E8-EFE1-4E18-BEE2-F4E65E56B52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935424" y="4320215"/>
                          <a:ext cx="497138" cy="41910"/>
                          <a:chOff x="5558790" y="222885"/>
                          <a:chExt cx="497138" cy="41910"/>
                        </a:xfrm>
                      </p:grpSpPr>
                      <p:cxnSp>
                        <p:nvCxnSpPr>
                          <p:cNvPr id="212" name="Straight Arrow Connector 211">
                            <a:extLst>
                              <a:ext uri="{FF2B5EF4-FFF2-40B4-BE49-F238E27FC236}">
                                <a16:creationId xmlns:a16="http://schemas.microsoft.com/office/drawing/2014/main" id="{B42C7284-4DBB-41EF-A826-B1DABE00A8BF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796636" y="262128"/>
                            <a:ext cx="259292" cy="0"/>
                          </a:xfrm>
                          <a:prstGeom prst="straightConnector1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13" name="Straight Connector 212">
                            <a:extLst>
                              <a:ext uri="{FF2B5EF4-FFF2-40B4-BE49-F238E27FC236}">
                                <a16:creationId xmlns:a16="http://schemas.microsoft.com/office/drawing/2014/main" id="{C815F775-4069-45B9-8951-60E9261B1143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V="1">
                            <a:off x="5800725" y="222885"/>
                            <a:ext cx="0" cy="4191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14" name="Straight Connector 213">
                            <a:extLst>
                              <a:ext uri="{FF2B5EF4-FFF2-40B4-BE49-F238E27FC236}">
                                <a16:creationId xmlns:a16="http://schemas.microsoft.com/office/drawing/2014/main" id="{DDDF93E7-B190-4C4B-8ADF-46C1624B4087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5558790" y="222885"/>
                            <a:ext cx="245466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199" name="Group 198">
                        <a:extLst>
                          <a:ext uri="{FF2B5EF4-FFF2-40B4-BE49-F238E27FC236}">
                            <a16:creationId xmlns:a16="http://schemas.microsoft.com/office/drawing/2014/main" id="{894AF4B7-E8D5-421B-AD57-67013A9DA60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850081" y="4561913"/>
                        <a:ext cx="911925" cy="245360"/>
                        <a:chOff x="4850081" y="4561913"/>
                        <a:chExt cx="911925" cy="245360"/>
                      </a:xfrm>
                    </p:grpSpPr>
                    <p:sp>
                      <p:nvSpPr>
                        <p:cNvPr id="205" name="TextBox 204">
                          <a:extLst>
                            <a:ext uri="{FF2B5EF4-FFF2-40B4-BE49-F238E27FC236}">
                              <a16:creationId xmlns:a16="http://schemas.microsoft.com/office/drawing/2014/main" id="{4A62F44A-5997-467A-B167-2063711AE42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850081" y="4607218"/>
                          <a:ext cx="911925" cy="20005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7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XR-Cass2-R-</a:t>
                          </a:r>
                          <a:r>
                            <a:rPr lang="en-US" sz="700" b="1" i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Sda</a:t>
                          </a:r>
                          <a:r>
                            <a:rPr lang="en-US" sz="700" b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</a:t>
                          </a:r>
                        </a:p>
                      </p:txBody>
                    </p:sp>
                    <p:grpSp>
                      <p:nvGrpSpPr>
                        <p:cNvPr id="206" name="Group 205">
                          <a:extLst>
                            <a:ext uri="{FF2B5EF4-FFF2-40B4-BE49-F238E27FC236}">
                              <a16:creationId xmlns:a16="http://schemas.microsoft.com/office/drawing/2014/main" id="{A08D855C-E025-469C-8171-3C4AFC484050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flipH="1" flipV="1">
                          <a:off x="5015596" y="4561913"/>
                          <a:ext cx="462915" cy="64787"/>
                          <a:chOff x="5558790" y="222885"/>
                          <a:chExt cx="497138" cy="41910"/>
                        </a:xfrm>
                      </p:grpSpPr>
                      <p:cxnSp>
                        <p:nvCxnSpPr>
                          <p:cNvPr id="207" name="Straight Arrow Connector 206">
                            <a:extLst>
                              <a:ext uri="{FF2B5EF4-FFF2-40B4-BE49-F238E27FC236}">
                                <a16:creationId xmlns:a16="http://schemas.microsoft.com/office/drawing/2014/main" id="{443DF17A-104B-403A-8272-713543D1EC55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796636" y="262128"/>
                            <a:ext cx="259292" cy="0"/>
                          </a:xfrm>
                          <a:prstGeom prst="straightConnector1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08" name="Straight Connector 207">
                            <a:extLst>
                              <a:ext uri="{FF2B5EF4-FFF2-40B4-BE49-F238E27FC236}">
                                <a16:creationId xmlns:a16="http://schemas.microsoft.com/office/drawing/2014/main" id="{F5504FF5-94C5-4631-B8CB-7D7D466F98FD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V="1">
                            <a:off x="5800725" y="222885"/>
                            <a:ext cx="0" cy="4191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09" name="Straight Connector 208">
                            <a:extLst>
                              <a:ext uri="{FF2B5EF4-FFF2-40B4-BE49-F238E27FC236}">
                                <a16:creationId xmlns:a16="http://schemas.microsoft.com/office/drawing/2014/main" id="{4E7AF431-961C-4989-B0B3-2855BDCAE20B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5558790" y="222885"/>
                            <a:ext cx="245466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200" name="Group 199">
                        <a:extLst>
                          <a:ext uri="{FF2B5EF4-FFF2-40B4-BE49-F238E27FC236}">
                            <a16:creationId xmlns:a16="http://schemas.microsoft.com/office/drawing/2014/main" id="{F59D03A2-9411-4B3E-9A61-A1E342F55FBE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171353" y="4413534"/>
                        <a:ext cx="1075587" cy="93868"/>
                        <a:chOff x="4171353" y="4413534"/>
                        <a:chExt cx="1075587" cy="93868"/>
                      </a:xfrm>
                    </p:grpSpPr>
                    <p:sp>
                      <p:nvSpPr>
                        <p:cNvPr id="201" name="Rectangle 200">
                          <a:extLst>
                            <a:ext uri="{FF2B5EF4-FFF2-40B4-BE49-F238E27FC236}">
                              <a16:creationId xmlns:a16="http://schemas.microsoft.com/office/drawing/2014/main" id="{171B2BBB-E7B0-4803-944A-CFF2C76C2152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71353" y="4413534"/>
                          <a:ext cx="426977" cy="91821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US" sz="6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sU3</a:t>
                          </a:r>
                        </a:p>
                      </p:txBody>
                    </p:sp>
                    <p:sp>
                      <p:nvSpPr>
                        <p:cNvPr id="202" name="Rectangle 201">
                          <a:extLst>
                            <a:ext uri="{FF2B5EF4-FFF2-40B4-BE49-F238E27FC236}">
                              <a16:creationId xmlns:a16="http://schemas.microsoft.com/office/drawing/2014/main" id="{226D7F04-9169-46ED-851C-CC41638668E1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601943" y="4415370"/>
                          <a:ext cx="208753" cy="91821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 sz="8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203" name="Rectangle 202">
                          <a:extLst>
                            <a:ext uri="{FF2B5EF4-FFF2-40B4-BE49-F238E27FC236}">
                              <a16:creationId xmlns:a16="http://schemas.microsoft.com/office/drawing/2014/main" id="{19451AED-E84F-4B28-A399-8E0911AA6143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820176" y="4415581"/>
                          <a:ext cx="361053" cy="91821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US" sz="5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RNA</a:t>
                          </a:r>
                        </a:p>
                      </p:txBody>
                    </p:sp>
                    <p:sp>
                      <p:nvSpPr>
                        <p:cNvPr id="204" name="Rectangle 203">
                          <a:extLst>
                            <a:ext uri="{FF2B5EF4-FFF2-40B4-BE49-F238E27FC236}">
                              <a16:creationId xmlns:a16="http://schemas.microsoft.com/office/drawing/2014/main" id="{EC3E6356-E792-41A6-8734-36F2A07B8F4B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5188798" y="4414803"/>
                          <a:ext cx="58142" cy="90607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 sz="8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197" name="TextBox 196">
                      <a:extLst>
                        <a:ext uri="{FF2B5EF4-FFF2-40B4-BE49-F238E27FC236}">
                          <a16:creationId xmlns:a16="http://schemas.microsoft.com/office/drawing/2014/main" id="{20E2402C-4623-4204-8EE7-39CB39D7C8A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33127" y="4285901"/>
                      <a:ext cx="340356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III</a:t>
                      </a:r>
                      <a:endParaRPr lang="en-US" sz="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grpSp>
              <p:nvGrpSpPr>
                <p:cNvPr id="248" name="Group 247">
                  <a:extLst>
                    <a:ext uri="{FF2B5EF4-FFF2-40B4-BE49-F238E27FC236}">
                      <a16:creationId xmlns:a16="http://schemas.microsoft.com/office/drawing/2014/main" id="{9CDAAEB6-72C6-4C76-BC42-D2421B1788EB}"/>
                    </a:ext>
                  </a:extLst>
                </p:cNvPr>
                <p:cNvGrpSpPr/>
                <p:nvPr/>
              </p:nvGrpSpPr>
              <p:grpSpPr>
                <a:xfrm>
                  <a:off x="705490" y="5745202"/>
                  <a:ext cx="2108196" cy="675506"/>
                  <a:chOff x="836450" y="5801019"/>
                  <a:chExt cx="2108196" cy="675506"/>
                </a:xfrm>
              </p:grpSpPr>
              <p:grpSp>
                <p:nvGrpSpPr>
                  <p:cNvPr id="221" name="Group 220">
                    <a:extLst>
                      <a:ext uri="{FF2B5EF4-FFF2-40B4-BE49-F238E27FC236}">
                        <a16:creationId xmlns:a16="http://schemas.microsoft.com/office/drawing/2014/main" id="{D6AD132A-3511-47AF-9F15-B741CAC53EE3}"/>
                      </a:ext>
                    </a:extLst>
                  </p:cNvPr>
                  <p:cNvGrpSpPr/>
                  <p:nvPr/>
                </p:nvGrpSpPr>
                <p:grpSpPr>
                  <a:xfrm>
                    <a:off x="836450" y="5801019"/>
                    <a:ext cx="2108196" cy="675506"/>
                    <a:chOff x="3653810" y="4131767"/>
                    <a:chExt cx="2108196" cy="675506"/>
                  </a:xfrm>
                </p:grpSpPr>
                <p:grpSp>
                  <p:nvGrpSpPr>
                    <p:cNvPr id="222" name="Group 221">
                      <a:extLst>
                        <a:ext uri="{FF2B5EF4-FFF2-40B4-BE49-F238E27FC236}">
                          <a16:creationId xmlns:a16="http://schemas.microsoft.com/office/drawing/2014/main" id="{E4698C01-AE8A-479C-B9E3-7238213B17B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653810" y="4131767"/>
                      <a:ext cx="2108196" cy="675506"/>
                      <a:chOff x="3653810" y="4131767"/>
                      <a:chExt cx="2108196" cy="675506"/>
                    </a:xfrm>
                  </p:grpSpPr>
                  <p:grpSp>
                    <p:nvGrpSpPr>
                      <p:cNvPr id="224" name="Group 223">
                        <a:extLst>
                          <a:ext uri="{FF2B5EF4-FFF2-40B4-BE49-F238E27FC236}">
                            <a16:creationId xmlns:a16="http://schemas.microsoft.com/office/drawing/2014/main" id="{C3256C84-BBC2-4EAE-98E2-B84E2E247AF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653810" y="4131767"/>
                        <a:ext cx="973671" cy="230358"/>
                        <a:chOff x="3653810" y="4131767"/>
                        <a:chExt cx="973671" cy="230358"/>
                      </a:xfrm>
                    </p:grpSpPr>
                    <p:sp>
                      <p:nvSpPr>
                        <p:cNvPr id="236" name="TextBox 235">
                          <a:extLst>
                            <a:ext uri="{FF2B5EF4-FFF2-40B4-BE49-F238E27FC236}">
                              <a16:creationId xmlns:a16="http://schemas.microsoft.com/office/drawing/2014/main" id="{6D73A599-63AD-4CD8-B7D0-DB9F111767F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653810" y="4131767"/>
                          <a:ext cx="973671" cy="20005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700" b="1" i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Hind</a:t>
                          </a:r>
                          <a:r>
                            <a:rPr lang="en-US" sz="700" b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II</a:t>
                          </a:r>
                          <a:r>
                            <a:rPr lang="en-US" sz="7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XR-Cass1-F</a:t>
                          </a:r>
                        </a:p>
                      </p:txBody>
                    </p:sp>
                    <p:grpSp>
                      <p:nvGrpSpPr>
                        <p:cNvPr id="237" name="Group 236">
                          <a:extLst>
                            <a:ext uri="{FF2B5EF4-FFF2-40B4-BE49-F238E27FC236}">
                              <a16:creationId xmlns:a16="http://schemas.microsoft.com/office/drawing/2014/main" id="{AFDB780D-179B-4FA6-8519-9125A592C3F1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3935424" y="4320215"/>
                          <a:ext cx="497138" cy="41910"/>
                          <a:chOff x="5558790" y="222885"/>
                          <a:chExt cx="497138" cy="41910"/>
                        </a:xfrm>
                      </p:grpSpPr>
                      <p:cxnSp>
                        <p:nvCxnSpPr>
                          <p:cNvPr id="238" name="Straight Arrow Connector 237">
                            <a:extLst>
                              <a:ext uri="{FF2B5EF4-FFF2-40B4-BE49-F238E27FC236}">
                                <a16:creationId xmlns:a16="http://schemas.microsoft.com/office/drawing/2014/main" id="{E87ECEAE-1BC6-4BFE-9CA0-0F7B5EB4D730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796636" y="262128"/>
                            <a:ext cx="259292" cy="0"/>
                          </a:xfrm>
                          <a:prstGeom prst="straightConnector1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39" name="Straight Connector 238">
                            <a:extLst>
                              <a:ext uri="{FF2B5EF4-FFF2-40B4-BE49-F238E27FC236}">
                                <a16:creationId xmlns:a16="http://schemas.microsoft.com/office/drawing/2014/main" id="{47FFFE2F-C142-4D42-BAD5-294E1747063F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V="1">
                            <a:off x="5800725" y="222885"/>
                            <a:ext cx="0" cy="4191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40" name="Straight Connector 239">
                            <a:extLst>
                              <a:ext uri="{FF2B5EF4-FFF2-40B4-BE49-F238E27FC236}">
                                <a16:creationId xmlns:a16="http://schemas.microsoft.com/office/drawing/2014/main" id="{9AE910F1-B588-4E65-9DF4-7358B429827E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5558790" y="222885"/>
                            <a:ext cx="245466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225" name="Group 224">
                        <a:extLst>
                          <a:ext uri="{FF2B5EF4-FFF2-40B4-BE49-F238E27FC236}">
                            <a16:creationId xmlns:a16="http://schemas.microsoft.com/office/drawing/2014/main" id="{3C17538E-CEB2-4DF5-9B22-6BA677E50C3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850081" y="4561913"/>
                        <a:ext cx="911925" cy="245360"/>
                        <a:chOff x="4850081" y="4561913"/>
                        <a:chExt cx="911925" cy="245360"/>
                      </a:xfrm>
                    </p:grpSpPr>
                    <p:sp>
                      <p:nvSpPr>
                        <p:cNvPr id="231" name="TextBox 230">
                          <a:extLst>
                            <a:ext uri="{FF2B5EF4-FFF2-40B4-BE49-F238E27FC236}">
                              <a16:creationId xmlns:a16="http://schemas.microsoft.com/office/drawing/2014/main" id="{72F690DD-AAD3-402C-AF7C-4B67753C031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850081" y="4607218"/>
                          <a:ext cx="911925" cy="20005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7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XR-Cass1-R-</a:t>
                          </a:r>
                          <a:r>
                            <a:rPr lang="en-US" sz="700" b="1" i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Kas</a:t>
                          </a:r>
                          <a:r>
                            <a:rPr lang="en-US" sz="700" b="1" dirty="0">
                              <a:solidFill>
                                <a:srgbClr val="FF0000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</a:t>
                          </a:r>
                        </a:p>
                      </p:txBody>
                    </p:sp>
                    <p:grpSp>
                      <p:nvGrpSpPr>
                        <p:cNvPr id="232" name="Group 231">
                          <a:extLst>
                            <a:ext uri="{FF2B5EF4-FFF2-40B4-BE49-F238E27FC236}">
                              <a16:creationId xmlns:a16="http://schemas.microsoft.com/office/drawing/2014/main" id="{1AFB97E7-0877-4522-B057-D02B6F855124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 flipH="1" flipV="1">
                          <a:off x="5015596" y="4561913"/>
                          <a:ext cx="462915" cy="64787"/>
                          <a:chOff x="5558790" y="222885"/>
                          <a:chExt cx="497138" cy="41910"/>
                        </a:xfrm>
                      </p:grpSpPr>
                      <p:cxnSp>
                        <p:nvCxnSpPr>
                          <p:cNvPr id="233" name="Straight Arrow Connector 232">
                            <a:extLst>
                              <a:ext uri="{FF2B5EF4-FFF2-40B4-BE49-F238E27FC236}">
                                <a16:creationId xmlns:a16="http://schemas.microsoft.com/office/drawing/2014/main" id="{B1A37658-F61A-4797-8F8D-99888F144262}"/>
                              </a:ext>
                            </a:extLst>
                          </p:cNvPr>
                          <p:cNvCxnSpPr>
                            <a:cxnSpLocks/>
                          </p:cNvCxnSpPr>
                          <p:nvPr/>
                        </p:nvCxnSpPr>
                        <p:spPr>
                          <a:xfrm>
                            <a:off x="5796636" y="262128"/>
                            <a:ext cx="259292" cy="0"/>
                          </a:xfrm>
                          <a:prstGeom prst="straightConnector1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34" name="Straight Connector 233">
                            <a:extLst>
                              <a:ext uri="{FF2B5EF4-FFF2-40B4-BE49-F238E27FC236}">
                                <a16:creationId xmlns:a16="http://schemas.microsoft.com/office/drawing/2014/main" id="{574AF8D1-1714-4A7B-9DB2-6D03E9B9FCE1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 flipV="1">
                            <a:off x="5800725" y="222885"/>
                            <a:ext cx="0" cy="4191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35" name="Straight Connector 234">
                            <a:extLst>
                              <a:ext uri="{FF2B5EF4-FFF2-40B4-BE49-F238E27FC236}">
                                <a16:creationId xmlns:a16="http://schemas.microsoft.com/office/drawing/2014/main" id="{DC0445B6-61EE-4A3E-8ED9-F3045851DD83}"/>
                              </a:ext>
                            </a:extLst>
                          </p:cNvPr>
                          <p:cNvCxnSpPr/>
                          <p:nvPr/>
                        </p:nvCxnSpPr>
                        <p:spPr>
                          <a:xfrm>
                            <a:off x="5558790" y="222885"/>
                            <a:ext cx="245466" cy="0"/>
                          </a:xfrm>
                          <a:prstGeom prst="line">
                            <a:avLst/>
                          </a:prstGeom>
                          <a:ln w="1270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</p:grpSp>
                  <p:grpSp>
                    <p:nvGrpSpPr>
                      <p:cNvPr id="226" name="Group 225">
                        <a:extLst>
                          <a:ext uri="{FF2B5EF4-FFF2-40B4-BE49-F238E27FC236}">
                            <a16:creationId xmlns:a16="http://schemas.microsoft.com/office/drawing/2014/main" id="{C8938488-D1C5-4F0D-988F-E4E8FCE2093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171353" y="4413534"/>
                        <a:ext cx="1075587" cy="93868"/>
                        <a:chOff x="4171353" y="4413534"/>
                        <a:chExt cx="1075587" cy="93868"/>
                      </a:xfrm>
                    </p:grpSpPr>
                    <p:sp>
                      <p:nvSpPr>
                        <p:cNvPr id="227" name="Rectangle 226">
                          <a:extLst>
                            <a:ext uri="{FF2B5EF4-FFF2-40B4-BE49-F238E27FC236}">
                              <a16:creationId xmlns:a16="http://schemas.microsoft.com/office/drawing/2014/main" id="{C20664A1-5575-4A07-A9C4-1306431D155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171353" y="4413534"/>
                          <a:ext cx="426977" cy="91821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US" sz="6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sU3</a:t>
                          </a:r>
                        </a:p>
                      </p:txBody>
                    </p:sp>
                    <p:sp>
                      <p:nvSpPr>
                        <p:cNvPr id="228" name="Rectangle 227">
                          <a:extLst>
                            <a:ext uri="{FF2B5EF4-FFF2-40B4-BE49-F238E27FC236}">
                              <a16:creationId xmlns:a16="http://schemas.microsoft.com/office/drawing/2014/main" id="{F3A54E74-3540-4F96-8B76-F0A6C06327D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601943" y="4415370"/>
                          <a:ext cx="208753" cy="91821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 sz="8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229" name="Rectangle 228">
                          <a:extLst>
                            <a:ext uri="{FF2B5EF4-FFF2-40B4-BE49-F238E27FC236}">
                              <a16:creationId xmlns:a16="http://schemas.microsoft.com/office/drawing/2014/main" id="{E1A58E4E-0B72-4CA2-92BE-711C9C6D67CE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4820176" y="4415581"/>
                          <a:ext cx="361053" cy="91821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r>
                            <a:rPr lang="en-US" sz="500" b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gRNA</a:t>
                          </a:r>
                        </a:p>
                      </p:txBody>
                    </p:sp>
                    <p:sp>
                      <p:nvSpPr>
                        <p:cNvPr id="230" name="Rectangle 229">
                          <a:extLst>
                            <a:ext uri="{FF2B5EF4-FFF2-40B4-BE49-F238E27FC236}">
                              <a16:creationId xmlns:a16="http://schemas.microsoft.com/office/drawing/2014/main" id="{64F4CF06-94AF-4CEC-A74E-7E6CC0A76F79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5188798" y="4416708"/>
                          <a:ext cx="58142" cy="90607"/>
                        </a:xfrm>
                        <a:prstGeom prst="rect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 sz="800" b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</p:grpSp>
                <p:sp>
                  <p:nvSpPr>
                    <p:cNvPr id="223" name="TextBox 222">
                      <a:extLst>
                        <a:ext uri="{FF2B5EF4-FFF2-40B4-BE49-F238E27FC236}">
                          <a16:creationId xmlns:a16="http://schemas.microsoft.com/office/drawing/2014/main" id="{C87742F4-F20B-4E38-9F98-31F6B796759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33127" y="4285901"/>
                      <a:ext cx="340356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olIII</a:t>
                      </a:r>
                      <a:endParaRPr lang="en-US" sz="4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183" name="Group 182">
                    <a:extLst>
                      <a:ext uri="{FF2B5EF4-FFF2-40B4-BE49-F238E27FC236}">
                        <a16:creationId xmlns:a16="http://schemas.microsoft.com/office/drawing/2014/main" id="{3E6AA943-61B2-44C6-BB97-E0CFF503247D}"/>
                      </a:ext>
                    </a:extLst>
                  </p:cNvPr>
                  <p:cNvGrpSpPr/>
                  <p:nvPr/>
                </p:nvGrpSpPr>
                <p:grpSpPr>
                  <a:xfrm>
                    <a:off x="1650022" y="5859157"/>
                    <a:ext cx="501314" cy="200055"/>
                    <a:chOff x="4502487" y="4293066"/>
                    <a:chExt cx="501314" cy="200055"/>
                  </a:xfrm>
                </p:grpSpPr>
                <p:sp>
                  <p:nvSpPr>
                    <p:cNvPr id="187" name="TextBox 186">
                      <a:extLst>
                        <a:ext uri="{FF2B5EF4-FFF2-40B4-BE49-F238E27FC236}">
                          <a16:creationId xmlns:a16="http://schemas.microsoft.com/office/drawing/2014/main" id="{15F34996-F1FD-4679-A6CB-B936F0D319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02487" y="4293066"/>
                      <a:ext cx="50131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KO-F</a:t>
                      </a:r>
                    </a:p>
                  </p:txBody>
                </p:sp>
                <p:cxnSp>
                  <p:nvCxnSpPr>
                    <p:cNvPr id="188" name="Straight Arrow Connector 187">
                      <a:extLst>
                        <a:ext uri="{FF2B5EF4-FFF2-40B4-BE49-F238E27FC236}">
                          <a16:creationId xmlns:a16="http://schemas.microsoft.com/office/drawing/2014/main" id="{5069E202-2D8E-4BAD-B472-8973249E060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642745" y="4472957"/>
                      <a:ext cx="174431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84" name="Group 183">
                    <a:extLst>
                      <a:ext uri="{FF2B5EF4-FFF2-40B4-BE49-F238E27FC236}">
                        <a16:creationId xmlns:a16="http://schemas.microsoft.com/office/drawing/2014/main" id="{6FD02FC7-37DC-4BC7-8E5F-8BAAEAE6C6F3}"/>
                      </a:ext>
                    </a:extLst>
                  </p:cNvPr>
                  <p:cNvGrpSpPr/>
                  <p:nvPr/>
                </p:nvGrpSpPr>
                <p:grpSpPr>
                  <a:xfrm>
                    <a:off x="1650022" y="6224345"/>
                    <a:ext cx="501314" cy="200055"/>
                    <a:chOff x="4502487" y="4658254"/>
                    <a:chExt cx="501314" cy="200055"/>
                  </a:xfrm>
                </p:grpSpPr>
                <p:sp>
                  <p:nvSpPr>
                    <p:cNvPr id="185" name="TextBox 184">
                      <a:extLst>
                        <a:ext uri="{FF2B5EF4-FFF2-40B4-BE49-F238E27FC236}">
                          <a16:creationId xmlns:a16="http://schemas.microsoft.com/office/drawing/2014/main" id="{7193AA0E-4BF5-45F9-A540-D8FBE46C30B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02487" y="4658254"/>
                      <a:ext cx="501314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7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KO-R</a:t>
                      </a:r>
                    </a:p>
                  </p:txBody>
                </p:sp>
                <p:cxnSp>
                  <p:nvCxnSpPr>
                    <p:cNvPr id="186" name="Straight Arrow Connector 185">
                      <a:extLst>
                        <a:ext uri="{FF2B5EF4-FFF2-40B4-BE49-F238E27FC236}">
                          <a16:creationId xmlns:a16="http://schemas.microsoft.com/office/drawing/2014/main" id="{8120C293-95CF-4C2B-9549-320D8BE715E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681099" y="4664799"/>
                      <a:ext cx="165633" cy="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250" name="Right Brace 249">
                  <a:extLst>
                    <a:ext uri="{FF2B5EF4-FFF2-40B4-BE49-F238E27FC236}">
                      <a16:creationId xmlns:a16="http://schemas.microsoft.com/office/drawing/2014/main" id="{3DA6782F-892B-469C-ADD4-A0396454587E}"/>
                    </a:ext>
                  </a:extLst>
                </p:cNvPr>
                <p:cNvSpPr/>
                <p:nvPr/>
              </p:nvSpPr>
              <p:spPr>
                <a:xfrm>
                  <a:off x="2831674" y="6076627"/>
                  <a:ext cx="128080" cy="688162"/>
                </a:xfrm>
                <a:prstGeom prst="rightBrace">
                  <a:avLst>
                    <a:gd name="adj1" fmla="val 140677"/>
                    <a:gd name="adj2" fmla="val 47798"/>
                  </a:avLst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51" name="TextBox 250">
                  <a:extLst>
                    <a:ext uri="{FF2B5EF4-FFF2-40B4-BE49-F238E27FC236}">
                      <a16:creationId xmlns:a16="http://schemas.microsoft.com/office/drawing/2014/main" id="{591A63B8-D2BE-4A86-8092-14E5A0D07D00}"/>
                    </a:ext>
                  </a:extLst>
                </p:cNvPr>
                <p:cNvSpPr txBox="1"/>
                <p:nvPr/>
              </p:nvSpPr>
              <p:spPr>
                <a:xfrm>
                  <a:off x="2942367" y="6170994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striction cloning by </a:t>
                  </a:r>
                </a:p>
                <a:p>
                  <a:pPr algn="ctr"/>
                  <a:r>
                    <a:rPr lang="en-US" sz="8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as</a:t>
                  </a:r>
                  <a:r>
                    <a:rPr lang="en-US" sz="8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US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2" name="TextBox 251">
                  <a:extLst>
                    <a:ext uri="{FF2B5EF4-FFF2-40B4-BE49-F238E27FC236}">
                      <a16:creationId xmlns:a16="http://schemas.microsoft.com/office/drawing/2014/main" id="{84F7BDB5-CF64-40AA-9F90-CFBD38C44981}"/>
                    </a:ext>
                  </a:extLst>
                </p:cNvPr>
                <p:cNvSpPr txBox="1"/>
                <p:nvPr/>
              </p:nvSpPr>
              <p:spPr>
                <a:xfrm>
                  <a:off x="3771075" y="6277879"/>
                  <a:ext cx="99097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 1</a:t>
                  </a:r>
                </a:p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XRCC4-cassette)</a:t>
                  </a:r>
                </a:p>
              </p:txBody>
            </p:sp>
            <p:cxnSp>
              <p:nvCxnSpPr>
                <p:cNvPr id="253" name="Straight Arrow Connector 252">
                  <a:extLst>
                    <a:ext uri="{FF2B5EF4-FFF2-40B4-BE49-F238E27FC236}">
                      <a16:creationId xmlns:a16="http://schemas.microsoft.com/office/drawing/2014/main" id="{A2EF7EB8-B627-489D-A205-7067FAC280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3706800" y="6394531"/>
                  <a:ext cx="175774" cy="427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4" name="TextBox 253">
                  <a:extLst>
                    <a:ext uri="{FF2B5EF4-FFF2-40B4-BE49-F238E27FC236}">
                      <a16:creationId xmlns:a16="http://schemas.microsoft.com/office/drawing/2014/main" id="{87DF1369-C44B-4138-A2F3-D1E0ED88B48F}"/>
                    </a:ext>
                  </a:extLst>
                </p:cNvPr>
                <p:cNvSpPr txBox="1"/>
                <p:nvPr/>
              </p:nvSpPr>
              <p:spPr>
                <a:xfrm>
                  <a:off x="3941885" y="5726390"/>
                  <a:ext cx="63671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RGEB31</a:t>
                  </a:r>
                </a:p>
              </p:txBody>
            </p:sp>
            <p:sp>
              <p:nvSpPr>
                <p:cNvPr id="255" name="Left Brace 254">
                  <a:extLst>
                    <a:ext uri="{FF2B5EF4-FFF2-40B4-BE49-F238E27FC236}">
                      <a16:creationId xmlns:a16="http://schemas.microsoft.com/office/drawing/2014/main" id="{6F1D2BB0-A216-40A4-86EA-887E0EA1FCDA}"/>
                    </a:ext>
                  </a:extLst>
                </p:cNvPr>
                <p:cNvSpPr/>
                <p:nvPr/>
              </p:nvSpPr>
              <p:spPr>
                <a:xfrm flipH="1">
                  <a:off x="4630380" y="5829973"/>
                  <a:ext cx="112200" cy="541977"/>
                </a:xfrm>
                <a:prstGeom prst="leftBrace">
                  <a:avLst>
                    <a:gd name="adj1" fmla="val 112355"/>
                    <a:gd name="adj2" fmla="val 50000"/>
                  </a:avLst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8E6354A2-FF5E-4092-943F-7A867266BD14}"/>
                    </a:ext>
                  </a:extLst>
                </p:cNvPr>
                <p:cNvSpPr txBox="1"/>
                <p:nvPr/>
              </p:nvSpPr>
              <p:spPr>
                <a:xfrm>
                  <a:off x="4629620" y="5835933"/>
                  <a:ext cx="911929" cy="5847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striction cloning by </a:t>
                  </a:r>
                </a:p>
                <a:p>
                  <a:pPr algn="ctr"/>
                  <a:r>
                    <a:rPr lang="en-US" sz="8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ind</a:t>
                  </a:r>
                  <a:r>
                    <a: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II </a:t>
                  </a:r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d</a:t>
                  </a:r>
                  <a:r>
                    <a: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US" sz="800" b="1" i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da</a:t>
                  </a:r>
                  <a:r>
                    <a:rPr lang="en-US" sz="800" b="1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endParaRPr lang="en-US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7" name="TextBox 256">
                  <a:extLst>
                    <a:ext uri="{FF2B5EF4-FFF2-40B4-BE49-F238E27FC236}">
                      <a16:creationId xmlns:a16="http://schemas.microsoft.com/office/drawing/2014/main" id="{6F6D1513-45D5-4A7D-9320-246C0E25FAEF}"/>
                    </a:ext>
                  </a:extLst>
                </p:cNvPr>
                <p:cNvSpPr txBox="1"/>
                <p:nvPr/>
              </p:nvSpPr>
              <p:spPr>
                <a:xfrm>
                  <a:off x="5467106" y="5919393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 2</a:t>
                  </a:r>
                </a:p>
              </p:txBody>
            </p:sp>
            <p:cxnSp>
              <p:nvCxnSpPr>
                <p:cNvPr id="258" name="Straight Arrow Connector 257">
                  <a:extLst>
                    <a:ext uri="{FF2B5EF4-FFF2-40B4-BE49-F238E27FC236}">
                      <a16:creationId xmlns:a16="http://schemas.microsoft.com/office/drawing/2014/main" id="{7E31E5A7-F149-4B23-8EC5-81E69A5E552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50261" y="6032974"/>
                  <a:ext cx="192014" cy="554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2" name="Group 271">
                <a:extLst>
                  <a:ext uri="{FF2B5EF4-FFF2-40B4-BE49-F238E27FC236}">
                    <a16:creationId xmlns:a16="http://schemas.microsoft.com/office/drawing/2014/main" id="{93E7CCD7-2EF5-41EC-B6D4-35ABEB364438}"/>
                  </a:ext>
                </a:extLst>
              </p:cNvPr>
              <p:cNvGrpSpPr/>
              <p:nvPr/>
            </p:nvGrpSpPr>
            <p:grpSpPr>
              <a:xfrm>
                <a:off x="856272" y="7308019"/>
                <a:ext cx="2440861" cy="678947"/>
                <a:chOff x="856272" y="7308019"/>
                <a:chExt cx="2440861" cy="678947"/>
              </a:xfrm>
            </p:grpSpPr>
            <p:sp>
              <p:nvSpPr>
                <p:cNvPr id="271" name="TextBox 270">
                  <a:extLst>
                    <a:ext uri="{FF2B5EF4-FFF2-40B4-BE49-F238E27FC236}">
                      <a16:creationId xmlns:a16="http://schemas.microsoft.com/office/drawing/2014/main" id="{0C7DA137-4833-4CA6-8DEE-801622A4BB82}"/>
                    </a:ext>
                  </a:extLst>
                </p:cNvPr>
                <p:cNvSpPr txBox="1"/>
                <p:nvPr/>
              </p:nvSpPr>
              <p:spPr>
                <a:xfrm>
                  <a:off x="1719339" y="7407979"/>
                  <a:ext cx="9119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Restriction cloning by </a:t>
                  </a:r>
                  <a:r>
                    <a:rPr lang="en-US" sz="8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da</a:t>
                  </a:r>
                  <a:r>
                    <a: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  <a:r>
                    <a:rPr lang="en-US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and </a:t>
                  </a:r>
                  <a:r>
                    <a:rPr lang="en-US" sz="800" b="1" i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me</a:t>
                  </a:r>
                  <a:r>
                    <a:rPr lang="en-US" sz="800" b="1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</a:t>
                  </a:r>
                </a:p>
              </p:txBody>
            </p:sp>
            <p:sp>
              <p:nvSpPr>
                <p:cNvPr id="264" name="TextBox 263">
                  <a:extLst>
                    <a:ext uri="{FF2B5EF4-FFF2-40B4-BE49-F238E27FC236}">
                      <a16:creationId xmlns:a16="http://schemas.microsoft.com/office/drawing/2014/main" id="{8F87F5F2-EC4A-4D78-8B2F-0D513609BB15}"/>
                    </a:ext>
                  </a:extLst>
                </p:cNvPr>
                <p:cNvSpPr txBox="1"/>
                <p:nvPr/>
              </p:nvSpPr>
              <p:spPr>
                <a:xfrm>
                  <a:off x="949448" y="7308019"/>
                  <a:ext cx="69602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ackbone 2</a:t>
                  </a:r>
                </a:p>
              </p:txBody>
            </p:sp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F06CA0B0-1D38-4F32-9DEA-95C661140FDE}"/>
                    </a:ext>
                  </a:extLst>
                </p:cNvPr>
                <p:cNvSpPr txBox="1"/>
                <p:nvPr/>
              </p:nvSpPr>
              <p:spPr>
                <a:xfrm>
                  <a:off x="856272" y="7771522"/>
                  <a:ext cx="82105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err="1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tMR</a:t>
                  </a:r>
                  <a:r>
                    <a:rPr lang="en-US" sz="800" b="1" dirty="0">
                      <a:solidFill>
                        <a:srgbClr val="C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cassette</a:t>
                  </a:r>
                </a:p>
              </p:txBody>
            </p:sp>
            <p:sp>
              <p:nvSpPr>
                <p:cNvPr id="266" name="Left Brace 265">
                  <a:extLst>
                    <a:ext uri="{FF2B5EF4-FFF2-40B4-BE49-F238E27FC236}">
                      <a16:creationId xmlns:a16="http://schemas.microsoft.com/office/drawing/2014/main" id="{7D6998C6-33C1-4921-8D11-637760D0C48E}"/>
                    </a:ext>
                  </a:extLst>
                </p:cNvPr>
                <p:cNvSpPr/>
                <p:nvPr/>
              </p:nvSpPr>
              <p:spPr>
                <a:xfrm flipH="1">
                  <a:off x="1626275" y="7413149"/>
                  <a:ext cx="112200" cy="498335"/>
                </a:xfrm>
                <a:prstGeom prst="leftBrace">
                  <a:avLst>
                    <a:gd name="adj1" fmla="val 112355"/>
                    <a:gd name="adj2" fmla="val 50000"/>
                  </a:avLst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8" name="TextBox 267">
                  <a:extLst>
                    <a:ext uri="{FF2B5EF4-FFF2-40B4-BE49-F238E27FC236}">
                      <a16:creationId xmlns:a16="http://schemas.microsoft.com/office/drawing/2014/main" id="{9470398E-B7FB-48D5-8EDA-5ED7707B1358}"/>
                    </a:ext>
                  </a:extLst>
                </p:cNvPr>
                <p:cNvSpPr txBox="1"/>
                <p:nvPr/>
              </p:nvSpPr>
              <p:spPr>
                <a:xfrm>
                  <a:off x="2674847" y="7518366"/>
                  <a:ext cx="62228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ggCtMR</a:t>
                  </a:r>
                  <a:endParaRPr lang="en-US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69" name="Straight Arrow Connector 268">
                  <a:extLst>
                    <a:ext uri="{FF2B5EF4-FFF2-40B4-BE49-F238E27FC236}">
                      <a16:creationId xmlns:a16="http://schemas.microsoft.com/office/drawing/2014/main" id="{A6A1AC71-63E4-4E50-AEE2-D084F1DBFB2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33766" y="7638811"/>
                  <a:ext cx="192014" cy="554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70" name="Left Brace 269">
            <a:extLst>
              <a:ext uri="{FF2B5EF4-FFF2-40B4-BE49-F238E27FC236}">
                <a16:creationId xmlns:a16="http://schemas.microsoft.com/office/drawing/2014/main" id="{4324AE96-B55C-4235-8506-11718C2979BE}"/>
              </a:ext>
            </a:extLst>
          </p:cNvPr>
          <p:cNvSpPr/>
          <p:nvPr/>
        </p:nvSpPr>
        <p:spPr>
          <a:xfrm>
            <a:off x="3019617" y="4507498"/>
            <a:ext cx="79043" cy="465308"/>
          </a:xfrm>
          <a:prstGeom prst="leftBrace">
            <a:avLst>
              <a:gd name="adj1" fmla="val 147169"/>
              <a:gd name="adj2" fmla="val 50000"/>
            </a:avLst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2617F191-1FFC-4E4F-92FA-13169D937951}"/>
              </a:ext>
            </a:extLst>
          </p:cNvPr>
          <p:cNvSpPr txBox="1"/>
          <p:nvPr/>
        </p:nvSpPr>
        <p:spPr>
          <a:xfrm>
            <a:off x="665345" y="8400976"/>
            <a:ext cx="5497786" cy="461665"/>
          </a:xfrm>
          <a:prstGeom prst="rect">
            <a:avLst/>
          </a:prstGeom>
          <a:noFill/>
          <a:ln w="12700">
            <a:noFill/>
          </a:ln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highlight>
                  <a:srgbClr val="FFFF00"/>
                </a:highlight>
                <a:cs typeface="Times New Roman" panose="02020603050405020304" pitchFamily="18" charset="0"/>
              </a:rPr>
              <a:t>Supplementary Figure 21 | </a:t>
            </a:r>
            <a:r>
              <a:rPr lang="en-US" sz="1200" dirty="0">
                <a:highlight>
                  <a:srgbClr val="FFFF00"/>
                </a:highlight>
                <a:cs typeface="Times New Roman" panose="02020603050405020304" pitchFamily="18" charset="0"/>
              </a:rPr>
              <a:t>Constructions of designed plasmids pgCtMR, pggCtMR, and </a:t>
            </a:r>
            <a:r>
              <a:rPr lang="en-US" sz="1200" dirty="0" err="1">
                <a:highlight>
                  <a:srgbClr val="FFFF00"/>
                </a:highlight>
                <a:cs typeface="Times New Roman" panose="02020603050405020304" pitchFamily="18" charset="0"/>
              </a:rPr>
              <a:t>pgg</a:t>
            </a:r>
            <a:r>
              <a:rPr lang="en-US" sz="1200" dirty="0">
                <a:highlight>
                  <a:srgbClr val="FFFF00"/>
                </a:highlight>
                <a:cs typeface="Times New Roman" panose="02020603050405020304" pitchFamily="18" charset="0"/>
              </a:rPr>
              <a:t> with their primer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061E02C-C63F-4557-AC72-B69026AE5C0F}"/>
              </a:ext>
            </a:extLst>
          </p:cNvPr>
          <p:cNvSpPr txBox="1"/>
          <p:nvPr/>
        </p:nvSpPr>
        <p:spPr>
          <a:xfrm>
            <a:off x="4382451" y="115392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B46F748-BF30-4F75-A763-D14C80804D9A}"/>
              </a:ext>
            </a:extLst>
          </p:cNvPr>
          <p:cNvSpPr txBox="1"/>
          <p:nvPr/>
        </p:nvSpPr>
        <p:spPr>
          <a:xfrm>
            <a:off x="1917736" y="381664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82672E4-06BD-4362-9161-817A8762DD7F}"/>
              </a:ext>
            </a:extLst>
          </p:cNvPr>
          <p:cNvSpPr txBox="1"/>
          <p:nvPr/>
        </p:nvSpPr>
        <p:spPr>
          <a:xfrm>
            <a:off x="3207678" y="45553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6D79EA5-E12E-4F4F-B7F4-0B12DDA59443}"/>
              </a:ext>
            </a:extLst>
          </p:cNvPr>
          <p:cNvSpPr txBox="1"/>
          <p:nvPr/>
        </p:nvSpPr>
        <p:spPr>
          <a:xfrm>
            <a:off x="4126792" y="589584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CAA47D4-B949-41EB-8DE6-A1CCD1892944}"/>
              </a:ext>
            </a:extLst>
          </p:cNvPr>
          <p:cNvSpPr txBox="1"/>
          <p:nvPr/>
        </p:nvSpPr>
        <p:spPr>
          <a:xfrm>
            <a:off x="1134530" y="744701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+</a:t>
            </a:r>
            <a:endParaRPr lang="en-US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83EB8A97-571E-46D2-9D01-0343BD208786}"/>
              </a:ext>
            </a:extLst>
          </p:cNvPr>
          <p:cNvGrpSpPr/>
          <p:nvPr/>
        </p:nvGrpSpPr>
        <p:grpSpPr>
          <a:xfrm>
            <a:off x="5154780" y="6437003"/>
            <a:ext cx="942070" cy="352900"/>
            <a:chOff x="5154780" y="6437003"/>
            <a:chExt cx="942070" cy="352900"/>
          </a:xfrm>
        </p:grpSpPr>
        <p:sp>
          <p:nvSpPr>
            <p:cNvPr id="216" name="Right Brace 215">
              <a:extLst>
                <a:ext uri="{FF2B5EF4-FFF2-40B4-BE49-F238E27FC236}">
                  <a16:creationId xmlns:a16="http://schemas.microsoft.com/office/drawing/2014/main" id="{8DA411D3-36E3-43A1-965B-18354E7EBBA7}"/>
                </a:ext>
              </a:extLst>
            </p:cNvPr>
            <p:cNvSpPr/>
            <p:nvPr/>
          </p:nvSpPr>
          <p:spPr>
            <a:xfrm rot="5400000">
              <a:off x="5563831" y="6027952"/>
              <a:ext cx="123968" cy="942070"/>
            </a:xfrm>
            <a:prstGeom prst="rightBrace">
              <a:avLst>
                <a:gd name="adj1" fmla="val 69106"/>
                <a:gd name="adj2" fmla="val 21189"/>
              </a:avLst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07D1E73C-298D-4760-A7BB-72EAD442E47A}"/>
                </a:ext>
              </a:extLst>
            </p:cNvPr>
            <p:cNvSpPr txBox="1"/>
            <p:nvPr/>
          </p:nvSpPr>
          <p:spPr>
            <a:xfrm>
              <a:off x="5731787" y="6574459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gg</a:t>
              </a:r>
              <a:endPara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60597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</TotalTime>
  <Words>140</Words>
  <Application>Microsoft Office PowerPoint</Application>
  <PresentationFormat>A4 Paper (210x297 mm)</PresentationFormat>
  <Paragraphs>8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21</cp:revision>
  <dcterms:created xsi:type="dcterms:W3CDTF">2022-05-10T05:11:22Z</dcterms:created>
  <dcterms:modified xsi:type="dcterms:W3CDTF">2022-05-12T02:08:55Z</dcterms:modified>
</cp:coreProperties>
</file>